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7"/>
  </p:notesMasterIdLst>
  <p:sldIdLst>
    <p:sldId id="462" r:id="rId2"/>
    <p:sldId id="463" r:id="rId3"/>
    <p:sldId id="464" r:id="rId4"/>
    <p:sldId id="466" r:id="rId5"/>
    <p:sldId id="465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00FF"/>
    <a:srgbClr val="0000CC"/>
    <a:srgbClr val="0432FF"/>
    <a:srgbClr val="008000"/>
    <a:srgbClr val="33CC33"/>
    <a:srgbClr val="FF9900"/>
    <a:srgbClr val="FFFF00"/>
    <a:srgbClr val="941651"/>
    <a:srgbClr val="009193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0" autoAdjust="0"/>
    <p:restoredTop sz="95238" autoAdjust="0"/>
  </p:normalViewPr>
  <p:slideViewPr>
    <p:cSldViewPr snapToGrid="0" showGuides="1">
      <p:cViewPr varScale="1">
        <p:scale>
          <a:sx n="98" d="100"/>
          <a:sy n="98" d="100"/>
        </p:scale>
        <p:origin x="148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20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shok Kumar" userId="ce358d56c435559e" providerId="LiveId" clId="{5C91AEA0-C588-4436-9570-4EF52926F9F3}"/>
    <pc:docChg chg="modSld">
      <pc:chgData name="Ashok Kumar" userId="ce358d56c435559e" providerId="LiveId" clId="{5C91AEA0-C588-4436-9570-4EF52926F9F3}" dt="2021-03-02T05:18:44.798" v="13" actId="20577"/>
      <pc:docMkLst>
        <pc:docMk/>
      </pc:docMkLst>
      <pc:sldChg chg="modSp mod">
        <pc:chgData name="Ashok Kumar" userId="ce358d56c435559e" providerId="LiveId" clId="{5C91AEA0-C588-4436-9570-4EF52926F9F3}" dt="2021-03-02T05:18:44.798" v="13" actId="20577"/>
        <pc:sldMkLst>
          <pc:docMk/>
          <pc:sldMk cId="1685013836" sldId="465"/>
        </pc:sldMkLst>
        <pc:spChg chg="mod">
          <ac:chgData name="Ashok Kumar" userId="ce358d56c435559e" providerId="LiveId" clId="{5C91AEA0-C588-4436-9570-4EF52926F9F3}" dt="2021-03-02T05:18:44.798" v="13" actId="20577"/>
          <ac:spMkLst>
            <pc:docMk/>
            <pc:sldMk cId="1685013836" sldId="465"/>
            <ac:spMk id="19" creationId="{82023E0B-8BC7-4816-9712-F9C33FD41548}"/>
          </ac:spMkLst>
        </pc:spChg>
      </pc:sldChg>
      <pc:sldChg chg="modSp mod">
        <pc:chgData name="Ashok Kumar" userId="ce358d56c435559e" providerId="LiveId" clId="{5C91AEA0-C588-4436-9570-4EF52926F9F3}" dt="2021-03-02T05:17:48.222" v="11" actId="1035"/>
        <pc:sldMkLst>
          <pc:docMk/>
          <pc:sldMk cId="3064015561" sldId="466"/>
        </pc:sldMkLst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8" creationId="{8CBB3E66-B71B-4B8B-ADF1-521F890AC17B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9" creationId="{42B38950-E4A8-47D2-B6B8-F5549DB4860C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10" creationId="{F4466EF7-0B00-4E13-AE35-CCDAE61D6E46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11" creationId="{EB870AF5-7AE9-4F8C-A2CC-3A440BE576FE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17" creationId="{10241820-F1E4-4C92-8DE8-5463508DE378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18" creationId="{7B6F457D-8820-468D-8F21-39DD9EF004CE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19" creationId="{62BE9843-2A17-45C0-8A14-8C7E6FC22EA8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20" creationId="{5AA16532-0608-4F18-97F8-79FBD06F40A2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28" creationId="{5EB22213-9DE3-4413-92BE-A8DC9AC0B0AF}"/>
          </ac:spMkLst>
        </pc:spChg>
        <pc:spChg chg="mod">
          <ac:chgData name="Ashok Kumar" userId="ce358d56c435559e" providerId="LiveId" clId="{5C91AEA0-C588-4436-9570-4EF52926F9F3}" dt="2021-03-02T05:17:48.222" v="11" actId="1035"/>
          <ac:spMkLst>
            <pc:docMk/>
            <pc:sldMk cId="3064015561" sldId="466"/>
            <ac:spMk id="33" creationId="{CD0A7932-C663-47CD-A2E4-F6FE618DAC5E}"/>
          </ac:spMkLst>
        </pc:spChg>
        <pc:grpChg chg="mod">
          <ac:chgData name="Ashok Kumar" userId="ce358d56c435559e" providerId="LiveId" clId="{5C91AEA0-C588-4436-9570-4EF52926F9F3}" dt="2021-03-02T05:17:48.222" v="11" actId="1035"/>
          <ac:grpSpMkLst>
            <pc:docMk/>
            <pc:sldMk cId="3064015561" sldId="466"/>
            <ac:grpSpMk id="21" creationId="{9DA42456-8768-4B48-8128-D1306FCFF347}"/>
          </ac:grpSpMkLst>
        </pc:grpChg>
        <pc:grpChg chg="mod">
          <ac:chgData name="Ashok Kumar" userId="ce358d56c435559e" providerId="LiveId" clId="{5C91AEA0-C588-4436-9570-4EF52926F9F3}" dt="2021-03-02T05:17:48.222" v="11" actId="1035"/>
          <ac:grpSpMkLst>
            <pc:docMk/>
            <pc:sldMk cId="3064015561" sldId="466"/>
            <ac:grpSpMk id="24" creationId="{E86A29E4-A719-42CF-A3A3-EE85759B2210}"/>
          </ac:grpSpMkLst>
        </pc:grpChg>
        <pc:grpChg chg="mod">
          <ac:chgData name="Ashok Kumar" userId="ce358d56c435559e" providerId="LiveId" clId="{5C91AEA0-C588-4436-9570-4EF52926F9F3}" dt="2021-03-02T05:17:48.222" v="11" actId="1035"/>
          <ac:grpSpMkLst>
            <pc:docMk/>
            <pc:sldMk cId="3064015561" sldId="466"/>
            <ac:grpSpMk id="30" creationId="{E137CD39-35E1-4462-B269-9B1240C83B32}"/>
          </ac:grpSpMkLst>
        </pc:grpChg>
        <pc:picChg chg="mod">
          <ac:chgData name="Ashok Kumar" userId="ce358d56c435559e" providerId="LiveId" clId="{5C91AEA0-C588-4436-9570-4EF52926F9F3}" dt="2021-03-02T05:17:48.222" v="11" actId="1035"/>
          <ac:picMkLst>
            <pc:docMk/>
            <pc:sldMk cId="3064015561" sldId="466"/>
            <ac:picMk id="4" creationId="{799F3E9C-C116-4505-BD15-675A34FC0363}"/>
          </ac:picMkLst>
        </pc:picChg>
        <pc:picChg chg="mod">
          <ac:chgData name="Ashok Kumar" userId="ce358d56c435559e" providerId="LiveId" clId="{5C91AEA0-C588-4436-9570-4EF52926F9F3}" dt="2021-03-02T05:17:48.222" v="11" actId="1035"/>
          <ac:picMkLst>
            <pc:docMk/>
            <pc:sldMk cId="3064015561" sldId="466"/>
            <ac:picMk id="5" creationId="{CA27F5CC-1C7F-4AF0-8655-B42DD04F68CD}"/>
          </ac:picMkLst>
        </pc:picChg>
        <pc:picChg chg="mod">
          <ac:chgData name="Ashok Kumar" userId="ce358d56c435559e" providerId="LiveId" clId="{5C91AEA0-C588-4436-9570-4EF52926F9F3}" dt="2021-03-02T05:17:48.222" v="11" actId="1035"/>
          <ac:picMkLst>
            <pc:docMk/>
            <pc:sldMk cId="3064015561" sldId="466"/>
            <ac:picMk id="6" creationId="{D7BEE1D7-FC31-4B51-81CD-5CFD37532377}"/>
          </ac:picMkLst>
        </pc:picChg>
        <pc:picChg chg="mod">
          <ac:chgData name="Ashok Kumar" userId="ce358d56c435559e" providerId="LiveId" clId="{5C91AEA0-C588-4436-9570-4EF52926F9F3}" dt="2021-03-02T05:17:48.222" v="11" actId="1035"/>
          <ac:picMkLst>
            <pc:docMk/>
            <pc:sldMk cId="3064015561" sldId="466"/>
            <ac:picMk id="7" creationId="{348F8821-7917-4AA0-9803-03422BB09D6D}"/>
          </ac:picMkLst>
        </pc:picChg>
      </pc:sldChg>
    </pc:docChg>
  </pc:docChgLst>
  <pc:docChgLst>
    <pc:chgData name="Ashok Kumar" userId="ce358d56c435559e" providerId="LiveId" clId="{FE155440-5B0A-4D3C-AD62-60D741ED8BB4}"/>
    <pc:docChg chg="custSel modSld">
      <pc:chgData name="Ashok Kumar" userId="ce358d56c435559e" providerId="LiveId" clId="{FE155440-5B0A-4D3C-AD62-60D741ED8BB4}" dt="2021-01-31T05:21:22.948" v="1382" actId="478"/>
      <pc:docMkLst>
        <pc:docMk/>
      </pc:docMkLst>
      <pc:sldChg chg="addSp delSp modSp mod">
        <pc:chgData name="Ashok Kumar" userId="ce358d56c435559e" providerId="LiveId" clId="{FE155440-5B0A-4D3C-AD62-60D741ED8BB4}" dt="2021-01-31T05:11:12.246" v="492" actId="1038"/>
        <pc:sldMkLst>
          <pc:docMk/>
          <pc:sldMk cId="2152862277" sldId="462"/>
        </pc:sldMkLst>
        <pc:spChg chg="del">
          <ac:chgData name="Ashok Kumar" userId="ce358d56c435559e" providerId="LiveId" clId="{FE155440-5B0A-4D3C-AD62-60D741ED8BB4}" dt="2021-01-31T05:02:06.746" v="1" actId="478"/>
          <ac:spMkLst>
            <pc:docMk/>
            <pc:sldMk cId="2152862277" sldId="462"/>
            <ac:spMk id="7" creationId="{EFDFD8CA-26A2-4A06-B5B4-5DD337A20221}"/>
          </ac:spMkLst>
        </pc:spChg>
        <pc:spChg chg="del">
          <ac:chgData name="Ashok Kumar" userId="ce358d56c435559e" providerId="LiveId" clId="{FE155440-5B0A-4D3C-AD62-60D741ED8BB4}" dt="2021-01-31T05:03:04.881" v="216" actId="478"/>
          <ac:spMkLst>
            <pc:docMk/>
            <pc:sldMk cId="2152862277" sldId="462"/>
            <ac:spMk id="10" creationId="{760022EA-E225-4C90-AE06-AA82A94682BA}"/>
          </ac:spMkLst>
        </pc:spChg>
        <pc:spChg chg="del mod">
          <ac:chgData name="Ashok Kumar" userId="ce358d56c435559e" providerId="LiveId" clId="{FE155440-5B0A-4D3C-AD62-60D741ED8BB4}" dt="2021-01-31T05:04:42.748" v="367" actId="478"/>
          <ac:spMkLst>
            <pc:docMk/>
            <pc:sldMk cId="2152862277" sldId="462"/>
            <ac:spMk id="11" creationId="{54F1CF05-D6F6-4690-8330-1456D4E15972}"/>
          </ac:spMkLst>
        </pc:spChg>
        <pc:spChg chg="mod">
          <ac:chgData name="Ashok Kumar" userId="ce358d56c435559e" providerId="LiveId" clId="{FE155440-5B0A-4D3C-AD62-60D741ED8BB4}" dt="2021-01-31T05:11:12.246" v="492" actId="1038"/>
          <ac:spMkLst>
            <pc:docMk/>
            <pc:sldMk cId="2152862277" sldId="462"/>
            <ac:spMk id="19" creationId="{34335E2C-4C9D-4111-8520-E5548008AD77}"/>
          </ac:spMkLst>
        </pc:spChg>
        <pc:spChg chg="mod">
          <ac:chgData name="Ashok Kumar" userId="ce358d56c435559e" providerId="LiveId" clId="{FE155440-5B0A-4D3C-AD62-60D741ED8BB4}" dt="2021-01-31T05:10:51.521" v="478" actId="1036"/>
          <ac:spMkLst>
            <pc:docMk/>
            <pc:sldMk cId="2152862277" sldId="462"/>
            <ac:spMk id="20" creationId="{E6538B3A-DB73-4A40-B280-DB79F09AB918}"/>
          </ac:spMkLst>
        </pc:spChg>
        <pc:spChg chg="mod">
          <ac:chgData name="Ashok Kumar" userId="ce358d56c435559e" providerId="LiveId" clId="{FE155440-5B0A-4D3C-AD62-60D741ED8BB4}" dt="2021-01-31T05:04:11.521" v="364" actId="1038"/>
          <ac:spMkLst>
            <pc:docMk/>
            <pc:sldMk cId="2152862277" sldId="462"/>
            <ac:spMk id="22" creationId="{5822A541-E2A0-4CBB-99B1-C2503016C69D}"/>
          </ac:spMkLst>
        </pc:spChg>
        <pc:spChg chg="mod">
          <ac:chgData name="Ashok Kumar" userId="ce358d56c435559e" providerId="LiveId" clId="{FE155440-5B0A-4D3C-AD62-60D741ED8BB4}" dt="2021-01-31T05:04:02.429" v="347" actId="1038"/>
          <ac:spMkLst>
            <pc:docMk/>
            <pc:sldMk cId="2152862277" sldId="462"/>
            <ac:spMk id="23" creationId="{1E93054D-05D2-4CB4-88BA-0353A9A58D47}"/>
          </ac:spMkLst>
        </pc:spChg>
        <pc:spChg chg="mod topLvl">
          <ac:chgData name="Ashok Kumar" userId="ce358d56c435559e" providerId="LiveId" clId="{FE155440-5B0A-4D3C-AD62-60D741ED8BB4}" dt="2021-01-31T05:05:23.532" v="450" actId="1038"/>
          <ac:spMkLst>
            <pc:docMk/>
            <pc:sldMk cId="2152862277" sldId="462"/>
            <ac:spMk id="25" creationId="{86BA769C-52BD-4EA9-B131-87664BF7F9E5}"/>
          </ac:spMkLst>
        </pc:spChg>
        <pc:spChg chg="del mod topLvl">
          <ac:chgData name="Ashok Kumar" userId="ce358d56c435559e" providerId="LiveId" clId="{FE155440-5B0A-4D3C-AD62-60D741ED8BB4}" dt="2021-01-31T05:05:14.785" v="436" actId="478"/>
          <ac:spMkLst>
            <pc:docMk/>
            <pc:sldMk cId="2152862277" sldId="462"/>
            <ac:spMk id="26" creationId="{5EF8642B-BC57-4D4E-B557-F1B1BB28B7CD}"/>
          </ac:spMkLst>
        </pc:spChg>
        <pc:grpChg chg="add mod">
          <ac:chgData name="Ashok Kumar" userId="ce358d56c435559e" providerId="LiveId" clId="{FE155440-5B0A-4D3C-AD62-60D741ED8BB4}" dt="2021-01-31T05:02:28.453" v="95" actId="1038"/>
          <ac:grpSpMkLst>
            <pc:docMk/>
            <pc:sldMk cId="2152862277" sldId="462"/>
            <ac:grpSpMk id="18" creationId="{F2F811AB-59C6-4D84-9702-300FE3BD009F}"/>
          </ac:grpSpMkLst>
        </pc:grpChg>
        <pc:grpChg chg="add mod">
          <ac:chgData name="Ashok Kumar" userId="ce358d56c435559e" providerId="LiveId" clId="{FE155440-5B0A-4D3C-AD62-60D741ED8BB4}" dt="2021-01-31T05:03:50.787" v="321" actId="14100"/>
          <ac:grpSpMkLst>
            <pc:docMk/>
            <pc:sldMk cId="2152862277" sldId="462"/>
            <ac:grpSpMk id="21" creationId="{68823077-87ED-4B0D-96A0-E0B834E7BDBA}"/>
          </ac:grpSpMkLst>
        </pc:grpChg>
        <pc:grpChg chg="add del mod">
          <ac:chgData name="Ashok Kumar" userId="ce358d56c435559e" providerId="LiveId" clId="{FE155440-5B0A-4D3C-AD62-60D741ED8BB4}" dt="2021-01-31T05:05:14.785" v="436" actId="478"/>
          <ac:grpSpMkLst>
            <pc:docMk/>
            <pc:sldMk cId="2152862277" sldId="462"/>
            <ac:grpSpMk id="24" creationId="{8CEDD77B-2391-44AA-A120-320A81F3EE8F}"/>
          </ac:grpSpMkLst>
        </pc:grpChg>
      </pc:sldChg>
      <pc:sldChg chg="addSp delSp modSp mod">
        <pc:chgData name="Ashok Kumar" userId="ce358d56c435559e" providerId="LiveId" clId="{FE155440-5B0A-4D3C-AD62-60D741ED8BB4}" dt="2021-01-31T05:13:11.031" v="730" actId="1038"/>
        <pc:sldMkLst>
          <pc:docMk/>
          <pc:sldMk cId="519043789" sldId="463"/>
        </pc:sldMkLst>
        <pc:spChg chg="del mod">
          <ac:chgData name="Ashok Kumar" userId="ce358d56c435559e" providerId="LiveId" clId="{FE155440-5B0A-4D3C-AD62-60D741ED8BB4}" dt="2021-01-31T05:11:24.979" v="493" actId="478"/>
          <ac:spMkLst>
            <pc:docMk/>
            <pc:sldMk cId="519043789" sldId="463"/>
            <ac:spMk id="16" creationId="{B0764EC6-0A0C-4BA9-9E96-95AE755673B2}"/>
          </ac:spMkLst>
        </pc:spChg>
        <pc:spChg chg="del">
          <ac:chgData name="Ashok Kumar" userId="ce358d56c435559e" providerId="LiveId" clId="{FE155440-5B0A-4D3C-AD62-60D741ED8BB4}" dt="2021-01-31T05:11:28.713" v="494" actId="478"/>
          <ac:spMkLst>
            <pc:docMk/>
            <pc:sldMk cId="519043789" sldId="463"/>
            <ac:spMk id="17" creationId="{B6933D52-D588-4B70-96E5-0910F0DF98EF}"/>
          </ac:spMkLst>
        </pc:spChg>
        <pc:spChg chg="del">
          <ac:chgData name="Ashok Kumar" userId="ce358d56c435559e" providerId="LiveId" clId="{FE155440-5B0A-4D3C-AD62-60D741ED8BB4}" dt="2021-01-31T05:11:32.280" v="495" actId="478"/>
          <ac:spMkLst>
            <pc:docMk/>
            <pc:sldMk cId="519043789" sldId="463"/>
            <ac:spMk id="18" creationId="{39E823C1-69B9-4DB1-8A7B-6C754F0B1A36}"/>
          </ac:spMkLst>
        </pc:spChg>
        <pc:spChg chg="mod">
          <ac:chgData name="Ashok Kumar" userId="ce358d56c435559e" providerId="LiveId" clId="{FE155440-5B0A-4D3C-AD62-60D741ED8BB4}" dt="2021-01-31T05:12:02.005" v="593" actId="1038"/>
          <ac:spMkLst>
            <pc:docMk/>
            <pc:sldMk cId="519043789" sldId="463"/>
            <ac:spMk id="38" creationId="{033D6D00-B0CA-4EBD-9E7A-7C02D70752D9}"/>
          </ac:spMkLst>
        </pc:spChg>
        <pc:spChg chg="mod">
          <ac:chgData name="Ashok Kumar" userId="ce358d56c435559e" providerId="LiveId" clId="{FE155440-5B0A-4D3C-AD62-60D741ED8BB4}" dt="2021-01-31T05:12:15.159" v="604" actId="1036"/>
          <ac:spMkLst>
            <pc:docMk/>
            <pc:sldMk cId="519043789" sldId="463"/>
            <ac:spMk id="39" creationId="{DB003A2A-CFDD-4508-86DE-878E41C8050C}"/>
          </ac:spMkLst>
        </pc:spChg>
        <pc:spChg chg="mod">
          <ac:chgData name="Ashok Kumar" userId="ce358d56c435559e" providerId="LiveId" clId="{FE155440-5B0A-4D3C-AD62-60D741ED8BB4}" dt="2021-01-31T05:13:11.031" v="730" actId="1038"/>
          <ac:spMkLst>
            <pc:docMk/>
            <pc:sldMk cId="519043789" sldId="463"/>
            <ac:spMk id="41" creationId="{4819F46A-9123-4BE9-859D-1952F37CB7C4}"/>
          </ac:spMkLst>
        </pc:spChg>
        <pc:spChg chg="mod">
          <ac:chgData name="Ashok Kumar" userId="ce358d56c435559e" providerId="LiveId" clId="{FE155440-5B0A-4D3C-AD62-60D741ED8BB4}" dt="2021-01-31T05:13:06.223" v="728" actId="1038"/>
          <ac:spMkLst>
            <pc:docMk/>
            <pc:sldMk cId="519043789" sldId="463"/>
            <ac:spMk id="42" creationId="{830C0B3D-1337-4FA7-98D3-A1ECF2514205}"/>
          </ac:spMkLst>
        </pc:spChg>
        <pc:spChg chg="mod">
          <ac:chgData name="Ashok Kumar" userId="ce358d56c435559e" providerId="LiveId" clId="{FE155440-5B0A-4D3C-AD62-60D741ED8BB4}" dt="2021-01-31T05:11:34.337" v="496"/>
          <ac:spMkLst>
            <pc:docMk/>
            <pc:sldMk cId="519043789" sldId="463"/>
            <ac:spMk id="44" creationId="{B4929DA2-4525-48B3-A102-A0E4AB6E32F1}"/>
          </ac:spMkLst>
        </pc:spChg>
        <pc:spChg chg="mod">
          <ac:chgData name="Ashok Kumar" userId="ce358d56c435559e" providerId="LiveId" clId="{FE155440-5B0A-4D3C-AD62-60D741ED8BB4}" dt="2021-01-31T05:12:43.482" v="672" actId="1035"/>
          <ac:spMkLst>
            <pc:docMk/>
            <pc:sldMk cId="519043789" sldId="463"/>
            <ac:spMk id="45" creationId="{F3B36150-B15B-422F-9807-53D47CDB59BA}"/>
          </ac:spMkLst>
        </pc:spChg>
        <pc:grpChg chg="add mod">
          <ac:chgData name="Ashok Kumar" userId="ce358d56c435559e" providerId="LiveId" clId="{FE155440-5B0A-4D3C-AD62-60D741ED8BB4}" dt="2021-01-31T05:11:48.296" v="587" actId="1038"/>
          <ac:grpSpMkLst>
            <pc:docMk/>
            <pc:sldMk cId="519043789" sldId="463"/>
            <ac:grpSpMk id="37" creationId="{A1989524-C588-4421-A6FF-66ACFC523FB2}"/>
          </ac:grpSpMkLst>
        </pc:grpChg>
        <pc:grpChg chg="add mod">
          <ac:chgData name="Ashok Kumar" userId="ce358d56c435559e" providerId="LiveId" clId="{FE155440-5B0A-4D3C-AD62-60D741ED8BB4}" dt="2021-01-31T05:12:57.836" v="712" actId="1038"/>
          <ac:grpSpMkLst>
            <pc:docMk/>
            <pc:sldMk cId="519043789" sldId="463"/>
            <ac:grpSpMk id="40" creationId="{DD1F545B-74F9-4213-A403-D77A6F4D187E}"/>
          </ac:grpSpMkLst>
        </pc:grpChg>
        <pc:grpChg chg="add mod">
          <ac:chgData name="Ashok Kumar" userId="ce358d56c435559e" providerId="LiveId" clId="{FE155440-5B0A-4D3C-AD62-60D741ED8BB4}" dt="2021-01-31T05:12:33.324" v="649" actId="1036"/>
          <ac:grpSpMkLst>
            <pc:docMk/>
            <pc:sldMk cId="519043789" sldId="463"/>
            <ac:grpSpMk id="43" creationId="{414C6AFD-A589-45A7-928D-9C4DF76886A8}"/>
          </ac:grpSpMkLst>
        </pc:grpChg>
      </pc:sldChg>
      <pc:sldChg chg="addSp delSp modSp mod">
        <pc:chgData name="Ashok Kumar" userId="ce358d56c435559e" providerId="LiveId" clId="{FE155440-5B0A-4D3C-AD62-60D741ED8BB4}" dt="2021-01-31T05:14:43.702" v="869" actId="478"/>
        <pc:sldMkLst>
          <pc:docMk/>
          <pc:sldMk cId="3007527024" sldId="464"/>
        </pc:sldMkLst>
        <pc:spChg chg="del">
          <ac:chgData name="Ashok Kumar" userId="ce358d56c435559e" providerId="LiveId" clId="{FE155440-5B0A-4D3C-AD62-60D741ED8BB4}" dt="2021-01-31T05:13:36.252" v="731" actId="478"/>
          <ac:spMkLst>
            <pc:docMk/>
            <pc:sldMk cId="3007527024" sldId="464"/>
            <ac:spMk id="11" creationId="{F1DEB4AE-1C89-42CD-840F-69F261962AED}"/>
          </ac:spMkLst>
        </pc:spChg>
        <pc:spChg chg="del">
          <ac:chgData name="Ashok Kumar" userId="ce358d56c435559e" providerId="LiveId" clId="{FE155440-5B0A-4D3C-AD62-60D741ED8BB4}" dt="2021-01-31T05:13:36.252" v="731" actId="478"/>
          <ac:spMkLst>
            <pc:docMk/>
            <pc:sldMk cId="3007527024" sldId="464"/>
            <ac:spMk id="12" creationId="{43D8D63E-E325-40FE-BD51-21C7ED9EF859}"/>
          </ac:spMkLst>
        </pc:spChg>
        <pc:spChg chg="del">
          <ac:chgData name="Ashok Kumar" userId="ce358d56c435559e" providerId="LiveId" clId="{FE155440-5B0A-4D3C-AD62-60D741ED8BB4}" dt="2021-01-31T05:13:36.252" v="731" actId="478"/>
          <ac:spMkLst>
            <pc:docMk/>
            <pc:sldMk cId="3007527024" sldId="464"/>
            <ac:spMk id="13" creationId="{03BEC361-CC30-4548-B982-F74A49D3F2BA}"/>
          </ac:spMkLst>
        </pc:spChg>
        <pc:spChg chg="mod">
          <ac:chgData name="Ashok Kumar" userId="ce358d56c435559e" providerId="LiveId" clId="{FE155440-5B0A-4D3C-AD62-60D741ED8BB4}" dt="2021-01-31T05:13:37.456" v="732"/>
          <ac:spMkLst>
            <pc:docMk/>
            <pc:sldMk cId="3007527024" sldId="464"/>
            <ac:spMk id="18" creationId="{CAA88D27-6941-4C7C-95EB-333F423831C6}"/>
          </ac:spMkLst>
        </pc:spChg>
        <pc:spChg chg="mod">
          <ac:chgData name="Ashok Kumar" userId="ce358d56c435559e" providerId="LiveId" clId="{FE155440-5B0A-4D3C-AD62-60D741ED8BB4}" dt="2021-01-31T05:13:37.456" v="732"/>
          <ac:spMkLst>
            <pc:docMk/>
            <pc:sldMk cId="3007527024" sldId="464"/>
            <ac:spMk id="19" creationId="{E877B2B5-B3B1-401E-82F7-139CF2302C5A}"/>
          </ac:spMkLst>
        </pc:spChg>
        <pc:spChg chg="del mod topLvl">
          <ac:chgData name="Ashok Kumar" userId="ce358d56c435559e" providerId="LiveId" clId="{FE155440-5B0A-4D3C-AD62-60D741ED8BB4}" dt="2021-01-31T05:14:22.601" v="828" actId="478"/>
          <ac:spMkLst>
            <pc:docMk/>
            <pc:sldMk cId="3007527024" sldId="464"/>
            <ac:spMk id="21" creationId="{9D19F29B-8AC3-4BF4-9564-5BCF5C79676F}"/>
          </ac:spMkLst>
        </pc:spChg>
        <pc:spChg chg="mod topLvl">
          <ac:chgData name="Ashok Kumar" userId="ce358d56c435559e" providerId="LiveId" clId="{FE155440-5B0A-4D3C-AD62-60D741ED8BB4}" dt="2021-01-31T05:14:22.601" v="828" actId="478"/>
          <ac:spMkLst>
            <pc:docMk/>
            <pc:sldMk cId="3007527024" sldId="464"/>
            <ac:spMk id="22" creationId="{90A443CD-BC84-4DB6-A795-75C21E91233C}"/>
          </ac:spMkLst>
        </pc:spChg>
        <pc:spChg chg="mod topLvl">
          <ac:chgData name="Ashok Kumar" userId="ce358d56c435559e" providerId="LiveId" clId="{FE155440-5B0A-4D3C-AD62-60D741ED8BB4}" dt="2021-01-31T05:14:43.702" v="869" actId="478"/>
          <ac:spMkLst>
            <pc:docMk/>
            <pc:sldMk cId="3007527024" sldId="464"/>
            <ac:spMk id="24" creationId="{EB5F32FC-6281-4DE0-BD30-CB425AEC8C2D}"/>
          </ac:spMkLst>
        </pc:spChg>
        <pc:spChg chg="del mod topLvl">
          <ac:chgData name="Ashok Kumar" userId="ce358d56c435559e" providerId="LiveId" clId="{FE155440-5B0A-4D3C-AD62-60D741ED8BB4}" dt="2021-01-31T05:14:43.702" v="869" actId="478"/>
          <ac:spMkLst>
            <pc:docMk/>
            <pc:sldMk cId="3007527024" sldId="464"/>
            <ac:spMk id="25" creationId="{1C3D24FE-5092-4F81-987B-8FEC01E8FCBB}"/>
          </ac:spMkLst>
        </pc:spChg>
        <pc:grpChg chg="add mod">
          <ac:chgData name="Ashok Kumar" userId="ce358d56c435559e" providerId="LiveId" clId="{FE155440-5B0A-4D3C-AD62-60D741ED8BB4}" dt="2021-01-31T05:13:52.036" v="785" actId="1037"/>
          <ac:grpSpMkLst>
            <pc:docMk/>
            <pc:sldMk cId="3007527024" sldId="464"/>
            <ac:grpSpMk id="17" creationId="{A2085372-9923-4E96-9325-BCF3792444F0}"/>
          </ac:grpSpMkLst>
        </pc:grpChg>
        <pc:grpChg chg="add del mod">
          <ac:chgData name="Ashok Kumar" userId="ce358d56c435559e" providerId="LiveId" clId="{FE155440-5B0A-4D3C-AD62-60D741ED8BB4}" dt="2021-01-31T05:14:22.601" v="828" actId="478"/>
          <ac:grpSpMkLst>
            <pc:docMk/>
            <pc:sldMk cId="3007527024" sldId="464"/>
            <ac:grpSpMk id="20" creationId="{6F7061F6-0457-4A91-9D7D-EA43CCD4F764}"/>
          </ac:grpSpMkLst>
        </pc:grpChg>
        <pc:grpChg chg="add del mod">
          <ac:chgData name="Ashok Kumar" userId="ce358d56c435559e" providerId="LiveId" clId="{FE155440-5B0A-4D3C-AD62-60D741ED8BB4}" dt="2021-01-31T05:14:43.702" v="869" actId="478"/>
          <ac:grpSpMkLst>
            <pc:docMk/>
            <pc:sldMk cId="3007527024" sldId="464"/>
            <ac:grpSpMk id="23" creationId="{6CEEE28D-DDB7-4F77-87DB-235B364D6A2B}"/>
          </ac:grpSpMkLst>
        </pc:grpChg>
      </pc:sldChg>
      <pc:sldChg chg="addSp delSp modSp mod">
        <pc:chgData name="Ashok Kumar" userId="ce358d56c435559e" providerId="LiveId" clId="{FE155440-5B0A-4D3C-AD62-60D741ED8BB4}" dt="2021-01-31T05:21:22.948" v="1382" actId="478"/>
        <pc:sldMkLst>
          <pc:docMk/>
          <pc:sldMk cId="1685013836" sldId="465"/>
        </pc:sldMkLst>
        <pc:spChg chg="del">
          <ac:chgData name="Ashok Kumar" userId="ce358d56c435559e" providerId="LiveId" clId="{FE155440-5B0A-4D3C-AD62-60D741ED8BB4}" dt="2021-01-31T05:19:51.208" v="1249" actId="478"/>
          <ac:spMkLst>
            <pc:docMk/>
            <pc:sldMk cId="1685013836" sldId="465"/>
            <ac:spMk id="16" creationId="{2502F1DF-6791-4186-B68F-701B8550DC39}"/>
          </ac:spMkLst>
        </pc:spChg>
        <pc:spChg chg="del">
          <ac:chgData name="Ashok Kumar" userId="ce358d56c435559e" providerId="LiveId" clId="{FE155440-5B0A-4D3C-AD62-60D741ED8BB4}" dt="2021-01-31T05:19:51.208" v="1249" actId="478"/>
          <ac:spMkLst>
            <pc:docMk/>
            <pc:sldMk cId="1685013836" sldId="465"/>
            <ac:spMk id="17" creationId="{9E55A5A0-03FD-444D-A50E-6E0D6E9CE8C7}"/>
          </ac:spMkLst>
        </pc:spChg>
        <pc:spChg chg="del">
          <ac:chgData name="Ashok Kumar" userId="ce358d56c435559e" providerId="LiveId" clId="{FE155440-5B0A-4D3C-AD62-60D741ED8BB4}" dt="2021-01-31T05:19:51.208" v="1249" actId="478"/>
          <ac:spMkLst>
            <pc:docMk/>
            <pc:sldMk cId="1685013836" sldId="465"/>
            <ac:spMk id="18" creationId="{19BEB45A-7171-4EA5-9E1E-5AEED4D71539}"/>
          </ac:spMkLst>
        </pc:spChg>
        <pc:spChg chg="add del mod">
          <ac:chgData name="Ashok Kumar" userId="ce358d56c435559e" providerId="LiveId" clId="{FE155440-5B0A-4D3C-AD62-60D741ED8BB4}" dt="2021-01-31T05:19:55.897" v="1251" actId="478"/>
          <ac:spMkLst>
            <pc:docMk/>
            <pc:sldMk cId="1685013836" sldId="465"/>
            <ac:spMk id="20" creationId="{8D79038E-A5B4-4C26-833C-094B52A43235}"/>
          </ac:spMkLst>
        </pc:spChg>
        <pc:spChg chg="mod">
          <ac:chgData name="Ashok Kumar" userId="ce358d56c435559e" providerId="LiveId" clId="{FE155440-5B0A-4D3C-AD62-60D741ED8BB4}" dt="2021-01-31T05:20:36.105" v="1316" actId="1038"/>
          <ac:spMkLst>
            <pc:docMk/>
            <pc:sldMk cId="1685013836" sldId="465"/>
            <ac:spMk id="22" creationId="{00C7B397-FBE7-48DB-9F94-857D9387D3D4}"/>
          </ac:spMkLst>
        </pc:spChg>
        <pc:spChg chg="mod">
          <ac:chgData name="Ashok Kumar" userId="ce358d56c435559e" providerId="LiveId" clId="{FE155440-5B0A-4D3C-AD62-60D741ED8BB4}" dt="2021-01-31T05:20:44.617" v="1321" actId="1038"/>
          <ac:spMkLst>
            <pc:docMk/>
            <pc:sldMk cId="1685013836" sldId="465"/>
            <ac:spMk id="23" creationId="{564CC4CE-1988-491D-867E-27D3979ED4BC}"/>
          </ac:spMkLst>
        </pc:spChg>
        <pc:spChg chg="mod">
          <ac:chgData name="Ashok Kumar" userId="ce358d56c435559e" providerId="LiveId" clId="{FE155440-5B0A-4D3C-AD62-60D741ED8BB4}" dt="2021-01-31T05:20:16.200" v="1252"/>
          <ac:spMkLst>
            <pc:docMk/>
            <pc:sldMk cId="1685013836" sldId="465"/>
            <ac:spMk id="25" creationId="{24BB1A9E-B004-407C-B583-AB72B4FD5FE7}"/>
          </ac:spMkLst>
        </pc:spChg>
        <pc:spChg chg="mod">
          <ac:chgData name="Ashok Kumar" userId="ce358d56c435559e" providerId="LiveId" clId="{FE155440-5B0A-4D3C-AD62-60D741ED8BB4}" dt="2021-01-31T05:21:10.020" v="1370" actId="1036"/>
          <ac:spMkLst>
            <pc:docMk/>
            <pc:sldMk cId="1685013836" sldId="465"/>
            <ac:spMk id="26" creationId="{F31632C7-0163-4755-A786-BC5B7E2A6445}"/>
          </ac:spMkLst>
        </pc:spChg>
        <pc:spChg chg="mod topLvl">
          <ac:chgData name="Ashok Kumar" userId="ce358d56c435559e" providerId="LiveId" clId="{FE155440-5B0A-4D3C-AD62-60D741ED8BB4}" dt="2021-01-31T05:21:22.948" v="1382" actId="478"/>
          <ac:spMkLst>
            <pc:docMk/>
            <pc:sldMk cId="1685013836" sldId="465"/>
            <ac:spMk id="28" creationId="{AA1D49E8-4EB0-44B4-BCBC-6A147D012D96}"/>
          </ac:spMkLst>
        </pc:spChg>
        <pc:spChg chg="del mod topLvl">
          <ac:chgData name="Ashok Kumar" userId="ce358d56c435559e" providerId="LiveId" clId="{FE155440-5B0A-4D3C-AD62-60D741ED8BB4}" dt="2021-01-31T05:21:22.948" v="1382" actId="478"/>
          <ac:spMkLst>
            <pc:docMk/>
            <pc:sldMk cId="1685013836" sldId="465"/>
            <ac:spMk id="29" creationId="{0EB3A5D4-5DDB-425F-BD89-8617B8E59744}"/>
          </ac:spMkLst>
        </pc:spChg>
        <pc:grpChg chg="add mod">
          <ac:chgData name="Ashok Kumar" userId="ce358d56c435559e" providerId="LiveId" clId="{FE155440-5B0A-4D3C-AD62-60D741ED8BB4}" dt="2021-01-31T05:20:24.587" v="1290" actId="1035"/>
          <ac:grpSpMkLst>
            <pc:docMk/>
            <pc:sldMk cId="1685013836" sldId="465"/>
            <ac:grpSpMk id="21" creationId="{C275E258-EEC2-42DC-B2A9-74E3C41814C2}"/>
          </ac:grpSpMkLst>
        </pc:grpChg>
        <pc:grpChg chg="add mod">
          <ac:chgData name="Ashok Kumar" userId="ce358d56c435559e" providerId="LiveId" clId="{FE155440-5B0A-4D3C-AD62-60D741ED8BB4}" dt="2021-01-31T05:20:55.456" v="1347" actId="1038"/>
          <ac:grpSpMkLst>
            <pc:docMk/>
            <pc:sldMk cId="1685013836" sldId="465"/>
            <ac:grpSpMk id="24" creationId="{6530851B-D07B-4840-8D51-577CE375D440}"/>
          </ac:grpSpMkLst>
        </pc:grpChg>
        <pc:grpChg chg="add del mod">
          <ac:chgData name="Ashok Kumar" userId="ce358d56c435559e" providerId="LiveId" clId="{FE155440-5B0A-4D3C-AD62-60D741ED8BB4}" dt="2021-01-31T05:21:22.948" v="1382" actId="478"/>
          <ac:grpSpMkLst>
            <pc:docMk/>
            <pc:sldMk cId="1685013836" sldId="465"/>
            <ac:grpSpMk id="27" creationId="{287EED13-05C5-49C5-B524-FDE278706D64}"/>
          </ac:grpSpMkLst>
        </pc:grpChg>
      </pc:sldChg>
      <pc:sldChg chg="addSp delSp modSp mod">
        <pc:chgData name="Ashok Kumar" userId="ce358d56c435559e" providerId="LiveId" clId="{FE155440-5B0A-4D3C-AD62-60D741ED8BB4}" dt="2021-01-31T05:19:34.319" v="1248" actId="20577"/>
        <pc:sldMkLst>
          <pc:docMk/>
          <pc:sldMk cId="3064015561" sldId="466"/>
        </pc:sldMkLst>
        <pc:spChg chg="del">
          <ac:chgData name="Ashok Kumar" userId="ce358d56c435559e" providerId="LiveId" clId="{FE155440-5B0A-4D3C-AD62-60D741ED8BB4}" dt="2021-01-31T05:16:09.040" v="915" actId="478"/>
          <ac:spMkLst>
            <pc:docMk/>
            <pc:sldMk cId="3064015561" sldId="466"/>
            <ac:spMk id="12" creationId="{F4A5F221-9CFA-446A-9D05-46816F3D3995}"/>
          </ac:spMkLst>
        </pc:spChg>
        <pc:spChg chg="del">
          <ac:chgData name="Ashok Kumar" userId="ce358d56c435559e" providerId="LiveId" clId="{FE155440-5B0A-4D3C-AD62-60D741ED8BB4}" dt="2021-01-31T05:16:12.069" v="916" actId="478"/>
          <ac:spMkLst>
            <pc:docMk/>
            <pc:sldMk cId="3064015561" sldId="466"/>
            <ac:spMk id="13" creationId="{A89A4C15-52B3-4BB2-9D8A-6AC1249A1092}"/>
          </ac:spMkLst>
        </pc:spChg>
        <pc:spChg chg="del">
          <ac:chgData name="Ashok Kumar" userId="ce358d56c435559e" providerId="LiveId" clId="{FE155440-5B0A-4D3C-AD62-60D741ED8BB4}" dt="2021-01-31T05:16:15.477" v="917" actId="478"/>
          <ac:spMkLst>
            <pc:docMk/>
            <pc:sldMk cId="3064015561" sldId="466"/>
            <ac:spMk id="14" creationId="{C13A5492-C8F6-4911-98F5-140AEF489B72}"/>
          </ac:spMkLst>
        </pc:spChg>
        <pc:spChg chg="del mod">
          <ac:chgData name="Ashok Kumar" userId="ce358d56c435559e" providerId="LiveId" clId="{FE155440-5B0A-4D3C-AD62-60D741ED8BB4}" dt="2021-01-31T05:16:01.801" v="913" actId="478"/>
          <ac:spMkLst>
            <pc:docMk/>
            <pc:sldMk cId="3064015561" sldId="466"/>
            <ac:spMk id="15" creationId="{5148E20A-02E7-45B5-9E0A-68A0E394BDB8}"/>
          </ac:spMkLst>
        </pc:spChg>
        <pc:spChg chg="del mod">
          <ac:chgData name="Ashok Kumar" userId="ce358d56c435559e" providerId="LiveId" clId="{FE155440-5B0A-4D3C-AD62-60D741ED8BB4}" dt="2021-01-31T05:16:01.801" v="913" actId="478"/>
          <ac:spMkLst>
            <pc:docMk/>
            <pc:sldMk cId="3064015561" sldId="466"/>
            <ac:spMk id="16" creationId="{7FC88003-366C-4334-92BB-E0F82900FA61}"/>
          </ac:spMkLst>
        </pc:spChg>
        <pc:spChg chg="mod">
          <ac:chgData name="Ashok Kumar" userId="ce358d56c435559e" providerId="LiveId" clId="{FE155440-5B0A-4D3C-AD62-60D741ED8BB4}" dt="2021-01-31T05:16:03.580" v="914"/>
          <ac:spMkLst>
            <pc:docMk/>
            <pc:sldMk cId="3064015561" sldId="466"/>
            <ac:spMk id="22" creationId="{58D53BE2-CC09-4F06-939F-66E4406CE1AF}"/>
          </ac:spMkLst>
        </pc:spChg>
        <pc:spChg chg="mod">
          <ac:chgData name="Ashok Kumar" userId="ce358d56c435559e" providerId="LiveId" clId="{FE155440-5B0A-4D3C-AD62-60D741ED8BB4}" dt="2021-01-31T05:17:51.681" v="1145" actId="1038"/>
          <ac:spMkLst>
            <pc:docMk/>
            <pc:sldMk cId="3064015561" sldId="466"/>
            <ac:spMk id="23" creationId="{BFA26CB7-EF89-4B6A-B594-CA04619AD4AB}"/>
          </ac:spMkLst>
        </pc:spChg>
        <pc:spChg chg="mod">
          <ac:chgData name="Ashok Kumar" userId="ce358d56c435559e" providerId="LiveId" clId="{FE155440-5B0A-4D3C-AD62-60D741ED8BB4}" dt="2021-01-31T05:16:03.580" v="914"/>
          <ac:spMkLst>
            <pc:docMk/>
            <pc:sldMk cId="3064015561" sldId="466"/>
            <ac:spMk id="25" creationId="{12C9CFCA-464F-462F-8B38-0D9EA44A8D87}"/>
          </ac:spMkLst>
        </pc:spChg>
        <pc:spChg chg="mod">
          <ac:chgData name="Ashok Kumar" userId="ce358d56c435559e" providerId="LiveId" clId="{FE155440-5B0A-4D3C-AD62-60D741ED8BB4}" dt="2021-01-31T05:17:10.707" v="1078" actId="1036"/>
          <ac:spMkLst>
            <pc:docMk/>
            <pc:sldMk cId="3064015561" sldId="466"/>
            <ac:spMk id="26" creationId="{5D2A1635-FD7D-4E56-9FBD-0E85D1D16B55}"/>
          </ac:spMkLst>
        </pc:spChg>
        <pc:spChg chg="mod topLvl">
          <ac:chgData name="Ashok Kumar" userId="ce358d56c435559e" providerId="LiveId" clId="{FE155440-5B0A-4D3C-AD62-60D741ED8BB4}" dt="2021-01-31T05:17:31.202" v="1139" actId="478"/>
          <ac:spMkLst>
            <pc:docMk/>
            <pc:sldMk cId="3064015561" sldId="466"/>
            <ac:spMk id="28" creationId="{5EB22213-9DE3-4413-92BE-A8DC9AC0B0AF}"/>
          </ac:spMkLst>
        </pc:spChg>
        <pc:spChg chg="del mod topLvl">
          <ac:chgData name="Ashok Kumar" userId="ce358d56c435559e" providerId="LiveId" clId="{FE155440-5B0A-4D3C-AD62-60D741ED8BB4}" dt="2021-01-31T05:17:31.202" v="1139" actId="478"/>
          <ac:spMkLst>
            <pc:docMk/>
            <pc:sldMk cId="3064015561" sldId="466"/>
            <ac:spMk id="29" creationId="{C97832BC-DACB-4748-B73B-4384B69710C5}"/>
          </ac:spMkLst>
        </pc:spChg>
        <pc:spChg chg="mod">
          <ac:chgData name="Ashok Kumar" userId="ce358d56c435559e" providerId="LiveId" clId="{FE155440-5B0A-4D3C-AD62-60D741ED8BB4}" dt="2021-01-31T05:19:07.055" v="1219" actId="1036"/>
          <ac:spMkLst>
            <pc:docMk/>
            <pc:sldMk cId="3064015561" sldId="466"/>
            <ac:spMk id="31" creationId="{24F26972-4DBD-41BC-9C50-6ECA9FA28121}"/>
          </ac:spMkLst>
        </pc:spChg>
        <pc:spChg chg="mod">
          <ac:chgData name="Ashok Kumar" userId="ce358d56c435559e" providerId="LiveId" clId="{FE155440-5B0A-4D3C-AD62-60D741ED8BB4}" dt="2021-01-31T05:18:23.592" v="1204" actId="20577"/>
          <ac:spMkLst>
            <pc:docMk/>
            <pc:sldMk cId="3064015561" sldId="466"/>
            <ac:spMk id="32" creationId="{212C4A17-5C5B-4354-8DC8-6B47359654F9}"/>
          </ac:spMkLst>
        </pc:spChg>
        <pc:spChg chg="add mod">
          <ac:chgData name="Ashok Kumar" userId="ce358d56c435559e" providerId="LiveId" clId="{FE155440-5B0A-4D3C-AD62-60D741ED8BB4}" dt="2021-01-31T05:19:34.319" v="1248" actId="20577"/>
          <ac:spMkLst>
            <pc:docMk/>
            <pc:sldMk cId="3064015561" sldId="466"/>
            <ac:spMk id="33" creationId="{CD0A7932-C663-47CD-A2E4-F6FE618DAC5E}"/>
          </ac:spMkLst>
        </pc:spChg>
        <pc:grpChg chg="add mod">
          <ac:chgData name="Ashok Kumar" userId="ce358d56c435559e" providerId="LiveId" clId="{FE155440-5B0A-4D3C-AD62-60D741ED8BB4}" dt="2021-01-31T05:16:40.054" v="999" actId="1036"/>
          <ac:grpSpMkLst>
            <pc:docMk/>
            <pc:sldMk cId="3064015561" sldId="466"/>
            <ac:grpSpMk id="21" creationId="{9DA42456-8768-4B48-8128-D1306FCFF347}"/>
          </ac:grpSpMkLst>
        </pc:grpChg>
        <pc:grpChg chg="add mod">
          <ac:chgData name="Ashok Kumar" userId="ce358d56c435559e" providerId="LiveId" clId="{FE155440-5B0A-4D3C-AD62-60D741ED8BB4}" dt="2021-01-31T05:18:04.560" v="1146" actId="14100"/>
          <ac:grpSpMkLst>
            <pc:docMk/>
            <pc:sldMk cId="3064015561" sldId="466"/>
            <ac:grpSpMk id="24" creationId="{E86A29E4-A719-42CF-A3A3-EE85759B2210}"/>
          </ac:grpSpMkLst>
        </pc:grpChg>
        <pc:grpChg chg="add del mod">
          <ac:chgData name="Ashok Kumar" userId="ce358d56c435559e" providerId="LiveId" clId="{FE155440-5B0A-4D3C-AD62-60D741ED8BB4}" dt="2021-01-31T05:17:31.202" v="1139" actId="478"/>
          <ac:grpSpMkLst>
            <pc:docMk/>
            <pc:sldMk cId="3064015561" sldId="466"/>
            <ac:grpSpMk id="27" creationId="{FB853F23-BAD1-4B82-A6E4-8DD8F8E083F9}"/>
          </ac:grpSpMkLst>
        </pc:grpChg>
        <pc:grpChg chg="add mod">
          <ac:chgData name="Ashok Kumar" userId="ce358d56c435559e" providerId="LiveId" clId="{FE155440-5B0A-4D3C-AD62-60D741ED8BB4}" dt="2021-01-31T05:18:18.651" v="1202" actId="1036"/>
          <ac:grpSpMkLst>
            <pc:docMk/>
            <pc:sldMk cId="3064015561" sldId="466"/>
            <ac:grpSpMk id="30" creationId="{E137CD39-35E1-4462-B269-9B1240C83B32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51DBEB-2CC7-4088-980B-8D07A87EE3A5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872F5E-779B-43DF-9E3C-AE0995F36A2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187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22F39-E226-4E6B-8721-7B9D58077419}" type="datetimeFigureOut">
              <a:rPr lang="en-US" smtClean="0"/>
              <a:pPr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500A7-FE68-4FB3-A828-E4D0E8AF237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4.wdp"/><Relationship Id="rId7" Type="http://schemas.openxmlformats.org/officeDocument/2006/relationships/image" Target="../media/image7.png"/><Relationship Id="rId12" Type="http://schemas.openxmlformats.org/officeDocument/2006/relationships/image" Target="../media/image11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g"/><Relationship Id="rId11" Type="http://schemas.openxmlformats.org/officeDocument/2006/relationships/image" Target="../media/image10.jpg"/><Relationship Id="rId5" Type="http://schemas.microsoft.com/office/2007/relationships/hdphoto" Target="../media/hdphoto5.wdp"/><Relationship Id="rId10" Type="http://schemas.microsoft.com/office/2007/relationships/hdphoto" Target="../media/hdphoto6.wdp"/><Relationship Id="rId4" Type="http://schemas.openxmlformats.org/officeDocument/2006/relationships/image" Target="../media/image5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microsoft.com/office/2007/relationships/hdphoto" Target="../media/hdphoto7.wdp"/><Relationship Id="rId7" Type="http://schemas.openxmlformats.org/officeDocument/2006/relationships/image" Target="../media/image18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g"/><Relationship Id="rId5" Type="http://schemas.microsoft.com/office/2007/relationships/hdphoto" Target="../media/hdphoto8.wdp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>
            <a:extLst>
              <a:ext uri="{FF2B5EF4-FFF2-40B4-BE49-F238E27FC236}">
                <a16:creationId xmlns:a16="http://schemas.microsoft.com/office/drawing/2014/main" id="{4EC56729-1A3B-4F24-947D-266D12E1CB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2000" contrast="-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13" t="21446" r="44866" b="65063"/>
          <a:stretch/>
        </p:blipFill>
        <p:spPr bwMode="auto">
          <a:xfrm>
            <a:off x="1507337" y="1504296"/>
            <a:ext cx="2883209" cy="143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D23DCB7-A0B6-4615-8E3D-28965E8890DF}"/>
              </a:ext>
            </a:extLst>
          </p:cNvPr>
          <p:cNvSpPr txBox="1"/>
          <p:nvPr/>
        </p:nvSpPr>
        <p:spPr>
          <a:xfrm>
            <a:off x="4365228" y="2086040"/>
            <a:ext cx="904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Y-H2AX</a:t>
            </a:r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CE1105D3-938D-4D4E-8B5D-33CDEE2EDED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8000" contrast="3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921" t="10463" r="45861" b="77351"/>
          <a:stretch/>
        </p:blipFill>
        <p:spPr bwMode="auto">
          <a:xfrm>
            <a:off x="1507337" y="3220278"/>
            <a:ext cx="2845257" cy="15313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08FEC013-F113-4EA9-B4A7-EB03DFB438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69" t="45374" r="47440" b="46058"/>
          <a:stretch/>
        </p:blipFill>
        <p:spPr bwMode="auto">
          <a:xfrm>
            <a:off x="1440955" y="5041548"/>
            <a:ext cx="2911195" cy="11339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47C8BB3-8845-454B-B93F-71935D8F83FB}"/>
              </a:ext>
            </a:extLst>
          </p:cNvPr>
          <p:cNvSpPr txBox="1"/>
          <p:nvPr/>
        </p:nvSpPr>
        <p:spPr>
          <a:xfrm>
            <a:off x="4303595" y="3715761"/>
            <a:ext cx="1667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pRPA32 (S4/S8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B4FE1A-3ABB-45DC-8812-7E4EE9332582}"/>
              </a:ext>
            </a:extLst>
          </p:cNvPr>
          <p:cNvSpPr txBox="1"/>
          <p:nvPr/>
        </p:nvSpPr>
        <p:spPr>
          <a:xfrm>
            <a:off x="4311035" y="5583029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GAPD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9C1A21-F4DD-428E-8A37-DE091CA3B415}"/>
              </a:ext>
            </a:extLst>
          </p:cNvPr>
          <p:cNvSpPr txBox="1"/>
          <p:nvPr/>
        </p:nvSpPr>
        <p:spPr>
          <a:xfrm>
            <a:off x="1534287" y="1195553"/>
            <a:ext cx="31181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CS        TTK    TPX2   RAD54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DBDC30-27AF-4B89-86C0-AA594BE5065F}"/>
              </a:ext>
            </a:extLst>
          </p:cNvPr>
          <p:cNvSpPr txBox="1"/>
          <p:nvPr/>
        </p:nvSpPr>
        <p:spPr>
          <a:xfrm>
            <a:off x="2823011" y="856882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Knockdown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8A5C0F2-739D-43CA-8E42-D876A12056AF}"/>
              </a:ext>
            </a:extLst>
          </p:cNvPr>
          <p:cNvSpPr txBox="1"/>
          <p:nvPr/>
        </p:nvSpPr>
        <p:spPr>
          <a:xfrm>
            <a:off x="1484244" y="85688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919082-D892-490D-816B-21D81430FD2F}"/>
              </a:ext>
            </a:extLst>
          </p:cNvPr>
          <p:cNvSpPr txBox="1"/>
          <p:nvPr/>
        </p:nvSpPr>
        <p:spPr>
          <a:xfrm>
            <a:off x="510209" y="200899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Figure 3 d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F2F811AB-59C6-4D84-9702-300FE3BD009F}"/>
              </a:ext>
            </a:extLst>
          </p:cNvPr>
          <p:cNvGrpSpPr/>
          <p:nvPr/>
        </p:nvGrpSpPr>
        <p:grpSpPr>
          <a:xfrm>
            <a:off x="1143533" y="1802241"/>
            <a:ext cx="738078" cy="827554"/>
            <a:chOff x="4999927" y="4759459"/>
            <a:chExt cx="526419" cy="690879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4335E2C-4C9D-4111-8520-E5548008AD77}"/>
                </a:ext>
              </a:extLst>
            </p:cNvPr>
            <p:cNvSpPr txBox="1"/>
            <p:nvPr/>
          </p:nvSpPr>
          <p:spPr>
            <a:xfrm>
              <a:off x="5040657" y="4759459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6538B3A-DB73-4A40-B280-DB79F09AB918}"/>
                </a:ext>
              </a:extLst>
            </p:cNvPr>
            <p:cNvSpPr txBox="1"/>
            <p:nvPr/>
          </p:nvSpPr>
          <p:spPr>
            <a:xfrm>
              <a:off x="4999927" y="5219088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5-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8823077-87ED-4B0D-96A0-E0B834E7BDBA}"/>
              </a:ext>
            </a:extLst>
          </p:cNvPr>
          <p:cNvGrpSpPr/>
          <p:nvPr/>
        </p:nvGrpSpPr>
        <p:grpSpPr>
          <a:xfrm>
            <a:off x="1170049" y="3518445"/>
            <a:ext cx="817779" cy="1914280"/>
            <a:chOff x="5025867" y="4535839"/>
            <a:chExt cx="508721" cy="50536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822A541-E2A0-4CBB-99B1-C2503016C69D}"/>
                </a:ext>
              </a:extLst>
            </p:cNvPr>
            <p:cNvSpPr txBox="1"/>
            <p:nvPr/>
          </p:nvSpPr>
          <p:spPr>
            <a:xfrm>
              <a:off x="5048899" y="4535839"/>
              <a:ext cx="485689" cy="731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E93054D-05D2-4CB4-88BA-0353A9A58D47}"/>
                </a:ext>
              </a:extLst>
            </p:cNvPr>
            <p:cNvSpPr txBox="1"/>
            <p:nvPr/>
          </p:nvSpPr>
          <p:spPr>
            <a:xfrm>
              <a:off x="5025867" y="4809953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5-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86BA769C-52BD-4EA9-B131-87664BF7F9E5}"/>
              </a:ext>
            </a:extLst>
          </p:cNvPr>
          <p:cNvSpPr txBox="1"/>
          <p:nvPr/>
        </p:nvSpPr>
        <p:spPr>
          <a:xfrm>
            <a:off x="1113101" y="5632177"/>
            <a:ext cx="762077" cy="426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</a:p>
        </p:txBody>
      </p:sp>
    </p:spTree>
    <p:extLst>
      <p:ext uri="{BB962C8B-B14F-4D97-AF65-F5344CB8AC3E}">
        <p14:creationId xmlns:p14="http://schemas.microsoft.com/office/powerpoint/2010/main" val="2152862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7" descr="图片包含 白色, 照片, 手, 蛋糕&#10;&#10;描述已自动生成">
            <a:extLst>
              <a:ext uri="{FF2B5EF4-FFF2-40B4-BE49-F238E27FC236}">
                <a16:creationId xmlns:a16="http://schemas.microsoft.com/office/drawing/2014/main" id="{580D17B9-5E06-4C1E-9BD4-2986EABC47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082" t="21500" r="52211" b="63200"/>
          <a:stretch/>
        </p:blipFill>
        <p:spPr>
          <a:xfrm>
            <a:off x="954161" y="2531163"/>
            <a:ext cx="2173355" cy="1280260"/>
          </a:xfrm>
          <a:prstGeom prst="rect">
            <a:avLst/>
          </a:prstGeom>
        </p:spPr>
      </p:pic>
      <p:pic>
        <p:nvPicPr>
          <p:cNvPr id="5" name="图片 15" descr="图片包含 白色, 照片, 黑色, 前&#10;&#10;描述已自动生成">
            <a:extLst>
              <a:ext uri="{FF2B5EF4-FFF2-40B4-BE49-F238E27FC236}">
                <a16:creationId xmlns:a16="http://schemas.microsoft.com/office/drawing/2014/main" id="{87D747C8-F022-4076-B902-954043F784D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4000" contras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665" t="28117" r="47445" b="58494"/>
          <a:stretch/>
        </p:blipFill>
        <p:spPr>
          <a:xfrm>
            <a:off x="954161" y="3935893"/>
            <a:ext cx="2185239" cy="1152939"/>
          </a:xfrm>
          <a:prstGeom prst="rect">
            <a:avLst/>
          </a:prstGeom>
        </p:spPr>
      </p:pic>
      <p:pic>
        <p:nvPicPr>
          <p:cNvPr id="6" name="图片 3" descr="图片包含 白色, 照片, 蛋糕, 黑色&#10;&#10;描述已自动生成">
            <a:extLst>
              <a:ext uri="{FF2B5EF4-FFF2-40B4-BE49-F238E27FC236}">
                <a16:creationId xmlns:a16="http://schemas.microsoft.com/office/drawing/2014/main" id="{7A857B0E-4F61-4AE5-B993-196EC0A03E5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53" t="19070" r="49581" b="65819"/>
          <a:stretch/>
        </p:blipFill>
        <p:spPr>
          <a:xfrm>
            <a:off x="966844" y="5267735"/>
            <a:ext cx="2147987" cy="1265316"/>
          </a:xfrm>
          <a:prstGeom prst="rect">
            <a:avLst/>
          </a:prstGeom>
        </p:spPr>
      </p:pic>
      <p:pic>
        <p:nvPicPr>
          <p:cNvPr id="7" name="图片 17" descr="图片包含 白色, 照片, 手, 蛋糕&#10;&#10;描述已自动生成">
            <a:extLst>
              <a:ext uri="{FF2B5EF4-FFF2-40B4-BE49-F238E27FC236}">
                <a16:creationId xmlns:a16="http://schemas.microsoft.com/office/drawing/2014/main" id="{30239933-DA42-42E3-BD0B-E76409AB1CE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76" t="22333" r="16147" b="62372"/>
          <a:stretch/>
        </p:blipFill>
        <p:spPr>
          <a:xfrm>
            <a:off x="3240040" y="2519103"/>
            <a:ext cx="2007824" cy="1304380"/>
          </a:xfrm>
          <a:prstGeom prst="rect">
            <a:avLst/>
          </a:prstGeom>
        </p:spPr>
      </p:pic>
      <p:pic>
        <p:nvPicPr>
          <p:cNvPr id="8" name="图片 15" descr="图片包含 白色, 照片, 黑色, 前&#10;&#10;描述已自动生成">
            <a:extLst>
              <a:ext uri="{FF2B5EF4-FFF2-40B4-BE49-F238E27FC236}">
                <a16:creationId xmlns:a16="http://schemas.microsoft.com/office/drawing/2014/main" id="{5CCED264-AC81-4FC7-9260-17DA0155985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6000" contras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598" t="27549" r="9513" b="58023"/>
          <a:stretch/>
        </p:blipFill>
        <p:spPr>
          <a:xfrm>
            <a:off x="3234772" y="3909390"/>
            <a:ext cx="2023587" cy="1268893"/>
          </a:xfrm>
          <a:prstGeom prst="rect">
            <a:avLst/>
          </a:prstGeom>
        </p:spPr>
      </p:pic>
      <p:pic>
        <p:nvPicPr>
          <p:cNvPr id="9" name="图片 3" descr="图片包含 白色, 照片, 蛋糕, 黑色&#10;&#10;描述已自动生成">
            <a:extLst>
              <a:ext uri="{FF2B5EF4-FFF2-40B4-BE49-F238E27FC236}">
                <a16:creationId xmlns:a16="http://schemas.microsoft.com/office/drawing/2014/main" id="{FEBCA742-248A-4C7C-B011-04EBABBA12A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3" t="19277" r="12314" b="65616"/>
          <a:stretch/>
        </p:blipFill>
        <p:spPr>
          <a:xfrm>
            <a:off x="3184908" y="5264190"/>
            <a:ext cx="2247715" cy="1335081"/>
          </a:xfrm>
          <a:prstGeom prst="rect">
            <a:avLst/>
          </a:prstGeom>
        </p:spPr>
      </p:pic>
      <p:pic>
        <p:nvPicPr>
          <p:cNvPr id="10" name="图片 9" descr="图片包含 白色, 照片, 黑色, 雪&#10;&#10;描述已自动生成">
            <a:extLst>
              <a:ext uri="{FF2B5EF4-FFF2-40B4-BE49-F238E27FC236}">
                <a16:creationId xmlns:a16="http://schemas.microsoft.com/office/drawing/2014/main" id="{ED119E5D-7C5F-4CB6-9F89-BC48E2768DB8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6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98" t="22759" r="50422" b="61943"/>
          <a:stretch/>
        </p:blipFill>
        <p:spPr>
          <a:xfrm>
            <a:off x="5360388" y="2531163"/>
            <a:ext cx="2944575" cy="1240504"/>
          </a:xfrm>
          <a:prstGeom prst="rect">
            <a:avLst/>
          </a:prstGeom>
        </p:spPr>
      </p:pic>
      <p:pic>
        <p:nvPicPr>
          <p:cNvPr id="11" name="图片 7" descr="图片包含 白色, 照片, 黑色, 男人&#10;&#10;描述已自动生成">
            <a:extLst>
              <a:ext uri="{FF2B5EF4-FFF2-40B4-BE49-F238E27FC236}">
                <a16:creationId xmlns:a16="http://schemas.microsoft.com/office/drawing/2014/main" id="{BEB407E1-B707-4FC3-99F3-FF8DFFD4B2C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8" t="26273" r="28156" b="59367"/>
          <a:stretch/>
        </p:blipFill>
        <p:spPr>
          <a:xfrm>
            <a:off x="5353731" y="3909390"/>
            <a:ext cx="3003687" cy="1181453"/>
          </a:xfrm>
          <a:prstGeom prst="rect">
            <a:avLst/>
          </a:prstGeom>
        </p:spPr>
      </p:pic>
      <p:pic>
        <p:nvPicPr>
          <p:cNvPr id="12" name="图片 5" descr="墙上的海报&#10;&#10;描述已自动生成">
            <a:extLst>
              <a:ext uri="{FF2B5EF4-FFF2-40B4-BE49-F238E27FC236}">
                <a16:creationId xmlns:a16="http://schemas.microsoft.com/office/drawing/2014/main" id="{176938D7-17D9-476B-B19D-A23A23C3946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87" t="27633" r="26347" b="56278"/>
          <a:stretch/>
        </p:blipFill>
        <p:spPr>
          <a:xfrm>
            <a:off x="5502700" y="5264190"/>
            <a:ext cx="2854718" cy="124050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7CDC755-DBCB-41D1-88F4-B15518FC9AB4}"/>
              </a:ext>
            </a:extLst>
          </p:cNvPr>
          <p:cNvSpPr txBox="1"/>
          <p:nvPr/>
        </p:nvSpPr>
        <p:spPr>
          <a:xfrm>
            <a:off x="8223977" y="2913002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𝛄-H2AX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7BB5853-04E1-434C-8016-6D5318671845}"/>
              </a:ext>
            </a:extLst>
          </p:cNvPr>
          <p:cNvSpPr txBox="1"/>
          <p:nvPr/>
        </p:nvSpPr>
        <p:spPr>
          <a:xfrm>
            <a:off x="8257092" y="5700969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FE482E-476D-4F99-A22D-78DCFC872AD8}"/>
              </a:ext>
            </a:extLst>
          </p:cNvPr>
          <p:cNvSpPr txBox="1"/>
          <p:nvPr/>
        </p:nvSpPr>
        <p:spPr>
          <a:xfrm>
            <a:off x="7949886" y="4348220"/>
            <a:ext cx="15645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PA32 (S4/S8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22E1EB3-BD5C-4128-87F1-29421FC7E8AF}"/>
              </a:ext>
            </a:extLst>
          </p:cNvPr>
          <p:cNvSpPr txBox="1"/>
          <p:nvPr/>
        </p:nvSpPr>
        <p:spPr>
          <a:xfrm>
            <a:off x="1021894" y="194002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27C2029-7DD3-4D98-80FF-522B971BC4E7}"/>
              </a:ext>
            </a:extLst>
          </p:cNvPr>
          <p:cNvSpPr txBox="1"/>
          <p:nvPr/>
        </p:nvSpPr>
        <p:spPr>
          <a:xfrm>
            <a:off x="1453140" y="1449363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Guide RNAs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6196620-6580-4988-8324-6A2C6173AF31}"/>
              </a:ext>
            </a:extLst>
          </p:cNvPr>
          <p:cNvSpPr/>
          <p:nvPr/>
        </p:nvSpPr>
        <p:spPr>
          <a:xfrm>
            <a:off x="2219337" y="1940022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RAD54B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D97580D-03F5-4B1B-8148-DD84F2101DA6}"/>
              </a:ext>
            </a:extLst>
          </p:cNvPr>
          <p:cNvSpPr txBox="1"/>
          <p:nvPr/>
        </p:nvSpPr>
        <p:spPr>
          <a:xfrm>
            <a:off x="3341635" y="194002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5E60099-F580-4671-BEF0-3B67FA8A6153}"/>
              </a:ext>
            </a:extLst>
          </p:cNvPr>
          <p:cNvSpPr txBox="1"/>
          <p:nvPr/>
        </p:nvSpPr>
        <p:spPr>
          <a:xfrm>
            <a:off x="3919257" y="1449358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Guide RNA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A047CFF-454C-48C1-ABD7-18224C6403B6}"/>
              </a:ext>
            </a:extLst>
          </p:cNvPr>
          <p:cNvSpPr/>
          <p:nvPr/>
        </p:nvSpPr>
        <p:spPr>
          <a:xfrm>
            <a:off x="4512574" y="1940022"/>
            <a:ext cx="7617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TPX2</a:t>
            </a:r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859C832-5D66-4996-B96B-E68275182388}"/>
              </a:ext>
            </a:extLst>
          </p:cNvPr>
          <p:cNvSpPr txBox="1"/>
          <p:nvPr/>
        </p:nvSpPr>
        <p:spPr>
          <a:xfrm>
            <a:off x="5827611" y="194002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531601-D44B-4DE0-BDFE-FFD7CE91E116}"/>
              </a:ext>
            </a:extLst>
          </p:cNvPr>
          <p:cNvSpPr txBox="1"/>
          <p:nvPr/>
        </p:nvSpPr>
        <p:spPr>
          <a:xfrm>
            <a:off x="6399210" y="1449361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Guide RNA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96A9107-129E-4695-A54B-2E3308051602}"/>
              </a:ext>
            </a:extLst>
          </p:cNvPr>
          <p:cNvSpPr/>
          <p:nvPr/>
        </p:nvSpPr>
        <p:spPr>
          <a:xfrm>
            <a:off x="7276846" y="1940022"/>
            <a:ext cx="6335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TTK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AC28A9E-1F84-4777-9921-49E3564884B1}"/>
              </a:ext>
            </a:extLst>
          </p:cNvPr>
          <p:cNvSpPr txBox="1"/>
          <p:nvPr/>
        </p:nvSpPr>
        <p:spPr>
          <a:xfrm>
            <a:off x="1160440" y="2203255"/>
            <a:ext cx="2108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1       2       1       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4896AB3-8879-41E8-9217-66431EB69A55}"/>
              </a:ext>
            </a:extLst>
          </p:cNvPr>
          <p:cNvSpPr txBox="1"/>
          <p:nvPr/>
        </p:nvSpPr>
        <p:spPr>
          <a:xfrm>
            <a:off x="3309713" y="2203255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1       2        1     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6EBF7F4-22F8-4FE1-82D6-A2768C5BF222}"/>
              </a:ext>
            </a:extLst>
          </p:cNvPr>
          <p:cNvSpPr txBox="1"/>
          <p:nvPr/>
        </p:nvSpPr>
        <p:spPr>
          <a:xfrm>
            <a:off x="5739084" y="2203255"/>
            <a:ext cx="2685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itchFamily="34" charset="0"/>
              </a:rPr>
              <a:t>1       2        1       2      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17BC0EF-AAE3-4DC9-9707-636A6D80D6D1}"/>
              </a:ext>
            </a:extLst>
          </p:cNvPr>
          <p:cNvSpPr txBox="1"/>
          <p:nvPr/>
        </p:nvSpPr>
        <p:spPr>
          <a:xfrm>
            <a:off x="3301879" y="-803709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RISPR/Cas9-mediated knockdow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04C0D5D-A6E6-4400-BEDE-531CDB9ECA5E}"/>
              </a:ext>
            </a:extLst>
          </p:cNvPr>
          <p:cNvSpPr/>
          <p:nvPr/>
        </p:nvSpPr>
        <p:spPr>
          <a:xfrm>
            <a:off x="777208" y="-80370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IV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0E822C2-D142-4398-AC81-E2EFEC44959F}"/>
              </a:ext>
            </a:extLst>
          </p:cNvPr>
          <p:cNvSpPr txBox="1"/>
          <p:nvPr/>
        </p:nvSpPr>
        <p:spPr>
          <a:xfrm>
            <a:off x="510209" y="200899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Figure 3 g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A1989524-C588-4421-A6FF-66ACFC523FB2}"/>
              </a:ext>
            </a:extLst>
          </p:cNvPr>
          <p:cNvGrpSpPr/>
          <p:nvPr/>
        </p:nvGrpSpPr>
        <p:grpSpPr>
          <a:xfrm>
            <a:off x="520685" y="2809469"/>
            <a:ext cx="751328" cy="748049"/>
            <a:chOff x="4999927" y="4372245"/>
            <a:chExt cx="535869" cy="624498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33D6D00-B0CA-4EBD-9E7A-7C02D70752D9}"/>
                </a:ext>
              </a:extLst>
            </p:cNvPr>
            <p:cNvSpPr txBox="1"/>
            <p:nvPr/>
          </p:nvSpPr>
          <p:spPr>
            <a:xfrm>
              <a:off x="5050107" y="4372245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B003A2A-CFDD-4508-86DE-878E41C8050C}"/>
                </a:ext>
              </a:extLst>
            </p:cNvPr>
            <p:cNvSpPr txBox="1"/>
            <p:nvPr/>
          </p:nvSpPr>
          <p:spPr>
            <a:xfrm>
              <a:off x="4999927" y="4765493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5-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DD1F545B-74F9-4213-A403-D77A6F4D187E}"/>
              </a:ext>
            </a:extLst>
          </p:cNvPr>
          <p:cNvGrpSpPr/>
          <p:nvPr/>
        </p:nvGrpSpPr>
        <p:grpSpPr>
          <a:xfrm>
            <a:off x="596373" y="4214226"/>
            <a:ext cx="861392" cy="1032962"/>
            <a:chOff x="5032878" y="4441382"/>
            <a:chExt cx="509132" cy="587458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819F46A-9123-4BE9-859D-1952F37CB7C4}"/>
                </a:ext>
              </a:extLst>
            </p:cNvPr>
            <p:cNvSpPr txBox="1"/>
            <p:nvPr/>
          </p:nvSpPr>
          <p:spPr>
            <a:xfrm>
              <a:off x="5056321" y="4441382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30C0B3D-1337-4FA7-98D3-A1ECF2514205}"/>
                </a:ext>
              </a:extLst>
            </p:cNvPr>
            <p:cNvSpPr txBox="1"/>
            <p:nvPr/>
          </p:nvSpPr>
          <p:spPr>
            <a:xfrm>
              <a:off x="5032878" y="4797590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5-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414C6AFD-A589-45A7-928D-9C4DF76886A8}"/>
              </a:ext>
            </a:extLst>
          </p:cNvPr>
          <p:cNvGrpSpPr/>
          <p:nvPr/>
        </p:nvGrpSpPr>
        <p:grpSpPr>
          <a:xfrm>
            <a:off x="586949" y="5652061"/>
            <a:ext cx="811151" cy="966721"/>
            <a:chOff x="5009379" y="4405434"/>
            <a:chExt cx="516965" cy="655609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4929DA2-4525-48B3-A102-A0E4AB6E32F1}"/>
                </a:ext>
              </a:extLst>
            </p:cNvPr>
            <p:cNvSpPr txBox="1"/>
            <p:nvPr/>
          </p:nvSpPr>
          <p:spPr>
            <a:xfrm>
              <a:off x="5040655" y="4405434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3B36150-B15B-422F-9807-53D47CDB59BA}"/>
                </a:ext>
              </a:extLst>
            </p:cNvPr>
            <p:cNvSpPr txBox="1"/>
            <p:nvPr/>
          </p:nvSpPr>
          <p:spPr>
            <a:xfrm>
              <a:off x="5009379" y="4829793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5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19043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27E00CE-A933-4B90-B7B8-45184C85582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lum bright="18000" contrast="27000"/>
          </a:blip>
          <a:srcRect l="-147" t="-3743" r="1015" b="-3840"/>
          <a:stretch/>
        </p:blipFill>
        <p:spPr bwMode="auto">
          <a:xfrm>
            <a:off x="2716695" y="2955241"/>
            <a:ext cx="3260035" cy="7612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7">
            <a:extLst>
              <a:ext uri="{FF2B5EF4-FFF2-40B4-BE49-F238E27FC236}">
                <a16:creationId xmlns:a16="http://schemas.microsoft.com/office/drawing/2014/main" id="{A2E24A4A-DD4E-4B79-ADBA-2518303FA63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l="901" t="5775" r="95" b="2268"/>
          <a:stretch/>
        </p:blipFill>
        <p:spPr bwMode="auto">
          <a:xfrm>
            <a:off x="2716695" y="3896139"/>
            <a:ext cx="3260035" cy="5633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297F5FFB-CA3D-4345-B8FC-1241D6C7E2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l="-4309" t="-14331" r="-403" b="-7913"/>
          <a:stretch/>
        </p:blipFill>
        <p:spPr bwMode="auto">
          <a:xfrm>
            <a:off x="2614677" y="4598504"/>
            <a:ext cx="3362053" cy="862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6593214-905A-4750-94C5-309D913C69D5}"/>
              </a:ext>
            </a:extLst>
          </p:cNvPr>
          <p:cNvSpPr txBox="1"/>
          <p:nvPr/>
        </p:nvSpPr>
        <p:spPr>
          <a:xfrm>
            <a:off x="5944597" y="3217806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𝛄-H2AX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E0F2D6E-CF4F-497A-9EBA-318B9641A6B1}"/>
              </a:ext>
            </a:extLst>
          </p:cNvPr>
          <p:cNvSpPr txBox="1"/>
          <p:nvPr/>
        </p:nvSpPr>
        <p:spPr>
          <a:xfrm>
            <a:off x="5937956" y="4852835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2C8542-0680-41E2-836D-4C2BC43E64AB}"/>
              </a:ext>
            </a:extLst>
          </p:cNvPr>
          <p:cNvSpPr txBox="1"/>
          <p:nvPr/>
        </p:nvSpPr>
        <p:spPr>
          <a:xfrm>
            <a:off x="5630750" y="3937407"/>
            <a:ext cx="15645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PA32 (S4/S8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02B971-8127-4838-869E-2A33CFF49E48}"/>
              </a:ext>
            </a:extLst>
          </p:cNvPr>
          <p:cNvSpPr txBox="1"/>
          <p:nvPr/>
        </p:nvSpPr>
        <p:spPr>
          <a:xfrm>
            <a:off x="2716695" y="2691493"/>
            <a:ext cx="37238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     C         TTK-O   TPX2-O  RAD54B-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FA8BE50-3A58-43BA-A4C7-202A38EAAF51}"/>
              </a:ext>
            </a:extLst>
          </p:cNvPr>
          <p:cNvSpPr txBox="1"/>
          <p:nvPr/>
        </p:nvSpPr>
        <p:spPr>
          <a:xfrm>
            <a:off x="510209" y="518951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Figure 5 b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2085372-9923-4E96-9325-BCF3792444F0}"/>
              </a:ext>
            </a:extLst>
          </p:cNvPr>
          <p:cNvGrpSpPr/>
          <p:nvPr/>
        </p:nvGrpSpPr>
        <p:grpSpPr>
          <a:xfrm>
            <a:off x="2349482" y="2955241"/>
            <a:ext cx="751328" cy="748049"/>
            <a:chOff x="4999927" y="4372245"/>
            <a:chExt cx="535869" cy="624498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AA88D27-6941-4C7C-95EB-333F423831C6}"/>
                </a:ext>
              </a:extLst>
            </p:cNvPr>
            <p:cNvSpPr txBox="1"/>
            <p:nvPr/>
          </p:nvSpPr>
          <p:spPr>
            <a:xfrm>
              <a:off x="5050107" y="4372245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877B2B5-B3B1-401E-82F7-139CF2302C5A}"/>
                </a:ext>
              </a:extLst>
            </p:cNvPr>
            <p:cNvSpPr txBox="1"/>
            <p:nvPr/>
          </p:nvSpPr>
          <p:spPr>
            <a:xfrm>
              <a:off x="4999927" y="4765493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5-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90A443CD-BC84-4DB6-A795-75C21E91233C}"/>
              </a:ext>
            </a:extLst>
          </p:cNvPr>
          <p:cNvSpPr txBox="1"/>
          <p:nvPr/>
        </p:nvSpPr>
        <p:spPr>
          <a:xfrm>
            <a:off x="2372162" y="4305675"/>
            <a:ext cx="821729" cy="4379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25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B5F32FC-6281-4DE0-BD30-CB425AEC8C2D}"/>
              </a:ext>
            </a:extLst>
          </p:cNvPr>
          <p:cNvSpPr txBox="1"/>
          <p:nvPr/>
        </p:nvSpPr>
        <p:spPr>
          <a:xfrm>
            <a:off x="2451571" y="4923211"/>
            <a:ext cx="762077" cy="340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</a:p>
        </p:txBody>
      </p:sp>
    </p:spTree>
    <p:extLst>
      <p:ext uri="{BB962C8B-B14F-4D97-AF65-F5344CB8AC3E}">
        <p14:creationId xmlns:p14="http://schemas.microsoft.com/office/powerpoint/2010/main" val="30075270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6" descr="图片包含 白色, 黑色, 照片, 前&#10;&#10;描述已自动生成">
            <a:extLst>
              <a:ext uri="{FF2B5EF4-FFF2-40B4-BE49-F238E27FC236}">
                <a16:creationId xmlns:a16="http://schemas.microsoft.com/office/drawing/2014/main" id="{799F3E9C-C116-4505-BD15-675A34FC036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56" t="30538" r="50186" b="61178"/>
          <a:stretch/>
        </p:blipFill>
        <p:spPr>
          <a:xfrm>
            <a:off x="2584171" y="1057881"/>
            <a:ext cx="3144760" cy="1205588"/>
          </a:xfrm>
          <a:prstGeom prst="rect">
            <a:avLst/>
          </a:prstGeom>
        </p:spPr>
      </p:pic>
      <p:pic>
        <p:nvPicPr>
          <p:cNvPr id="5" name="图片 4" descr="图片包含 白色, 照片, 黑色, 街道&#10;&#10;描述已自动生成">
            <a:extLst>
              <a:ext uri="{FF2B5EF4-FFF2-40B4-BE49-F238E27FC236}">
                <a16:creationId xmlns:a16="http://schemas.microsoft.com/office/drawing/2014/main" id="{CA27F5CC-1C7F-4AF0-8655-B42DD04F68C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44" t="31970" r="49109" b="56114"/>
          <a:stretch/>
        </p:blipFill>
        <p:spPr>
          <a:xfrm>
            <a:off x="2584171" y="2438405"/>
            <a:ext cx="3154016" cy="1360604"/>
          </a:xfrm>
          <a:prstGeom prst="rect">
            <a:avLst/>
          </a:prstGeom>
        </p:spPr>
      </p:pic>
      <p:pic>
        <p:nvPicPr>
          <p:cNvPr id="6" name="图片 10" descr="墙上贴着海报&#10;&#10;描述已自动生成">
            <a:extLst>
              <a:ext uri="{FF2B5EF4-FFF2-40B4-BE49-F238E27FC236}">
                <a16:creationId xmlns:a16="http://schemas.microsoft.com/office/drawing/2014/main" id="{D7BEE1D7-FC31-4B51-81CD-5CFD3753237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5" t="41437" r="50933" b="44962"/>
          <a:stretch/>
        </p:blipFill>
        <p:spPr>
          <a:xfrm>
            <a:off x="2633813" y="3892829"/>
            <a:ext cx="3104374" cy="1429238"/>
          </a:xfrm>
          <a:prstGeom prst="rect">
            <a:avLst/>
          </a:prstGeom>
        </p:spPr>
      </p:pic>
      <p:pic>
        <p:nvPicPr>
          <p:cNvPr id="7" name="图片 8" descr="街道边立着牌子&#10;&#10;描述已自动生成">
            <a:extLst>
              <a:ext uri="{FF2B5EF4-FFF2-40B4-BE49-F238E27FC236}">
                <a16:creationId xmlns:a16="http://schemas.microsoft.com/office/drawing/2014/main" id="{348F8821-7917-4AA0-9803-03422BB09D6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26" t="41860" r="49931" b="47235"/>
          <a:stretch/>
        </p:blipFill>
        <p:spPr>
          <a:xfrm>
            <a:off x="2615243" y="5415887"/>
            <a:ext cx="3104374" cy="13299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CBB3E66-B71B-4B8B-ADF1-521F890AC17B}"/>
              </a:ext>
            </a:extLst>
          </p:cNvPr>
          <p:cNvSpPr txBox="1"/>
          <p:nvPr/>
        </p:nvSpPr>
        <p:spPr>
          <a:xfrm>
            <a:off x="5626549" y="1349251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𝛄-H2AX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B38950-E4A8-47D2-B6B8-F5549DB4860C}"/>
              </a:ext>
            </a:extLst>
          </p:cNvPr>
          <p:cNvSpPr txBox="1"/>
          <p:nvPr/>
        </p:nvSpPr>
        <p:spPr>
          <a:xfrm>
            <a:off x="5659664" y="6085283"/>
            <a:ext cx="9236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466EF7-0B00-4E13-AE35-CCDAE61D6E46}"/>
              </a:ext>
            </a:extLst>
          </p:cNvPr>
          <p:cNvSpPr txBox="1"/>
          <p:nvPr/>
        </p:nvSpPr>
        <p:spPr>
          <a:xfrm>
            <a:off x="5352458" y="2943493"/>
            <a:ext cx="15645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PA32 (S4/S8)</a:t>
            </a:r>
          </a:p>
        </p:txBody>
      </p:sp>
      <p:sp>
        <p:nvSpPr>
          <p:cNvPr id="11" name="文本框 14">
            <a:extLst>
              <a:ext uri="{FF2B5EF4-FFF2-40B4-BE49-F238E27FC236}">
                <a16:creationId xmlns:a16="http://schemas.microsoft.com/office/drawing/2014/main" id="{EB870AF5-7AE9-4F8C-A2CC-3A440BE576FE}"/>
              </a:ext>
            </a:extLst>
          </p:cNvPr>
          <p:cNvSpPr txBox="1"/>
          <p:nvPr/>
        </p:nvSpPr>
        <p:spPr>
          <a:xfrm>
            <a:off x="5716793" y="4477846"/>
            <a:ext cx="7368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241820-F1E4-4C92-8DE8-5463508DE378}"/>
              </a:ext>
            </a:extLst>
          </p:cNvPr>
          <p:cNvSpPr txBox="1"/>
          <p:nvPr/>
        </p:nvSpPr>
        <p:spPr>
          <a:xfrm>
            <a:off x="2800331" y="496627"/>
            <a:ext cx="30396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  C       TTKI      ET     ET+TTK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6F457D-8820-468D-8F21-39DD9EF004CE}"/>
              </a:ext>
            </a:extLst>
          </p:cNvPr>
          <p:cNvSpPr txBox="1"/>
          <p:nvPr/>
        </p:nvSpPr>
        <p:spPr>
          <a:xfrm>
            <a:off x="3411994" y="771650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2BE9843-2A17-45C0-8A14-8C7E6FC22EA8}"/>
              </a:ext>
            </a:extLst>
          </p:cNvPr>
          <p:cNvSpPr txBox="1"/>
          <p:nvPr/>
        </p:nvSpPr>
        <p:spPr>
          <a:xfrm>
            <a:off x="4093311" y="771650"/>
            <a:ext cx="705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1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AA16532-0608-4F18-97F8-79FBD06F40A2}"/>
              </a:ext>
            </a:extLst>
          </p:cNvPr>
          <p:cNvSpPr txBox="1"/>
          <p:nvPr/>
        </p:nvSpPr>
        <p:spPr>
          <a:xfrm>
            <a:off x="510209" y="161147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Figure 7 b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DA42456-8768-4B48-8128-D1306FCFF347}"/>
              </a:ext>
            </a:extLst>
          </p:cNvPr>
          <p:cNvGrpSpPr/>
          <p:nvPr/>
        </p:nvGrpSpPr>
        <p:grpSpPr>
          <a:xfrm>
            <a:off x="2230219" y="1099934"/>
            <a:ext cx="738076" cy="681785"/>
            <a:chOff x="5009379" y="4372245"/>
            <a:chExt cx="526417" cy="569179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8D53BE2-CC09-4F06-939F-66E4406CE1AF}"/>
                </a:ext>
              </a:extLst>
            </p:cNvPr>
            <p:cNvSpPr txBox="1"/>
            <p:nvPr/>
          </p:nvSpPr>
          <p:spPr>
            <a:xfrm>
              <a:off x="5050107" y="4372245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FA26CB7-EF89-4B6A-B594-CA04619AD4AB}"/>
                </a:ext>
              </a:extLst>
            </p:cNvPr>
            <p:cNvSpPr txBox="1"/>
            <p:nvPr/>
          </p:nvSpPr>
          <p:spPr>
            <a:xfrm>
              <a:off x="5009379" y="4710174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5-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E86A29E4-A719-42CF-A3A3-EE85759B2210}"/>
              </a:ext>
            </a:extLst>
          </p:cNvPr>
          <p:cNvGrpSpPr/>
          <p:nvPr/>
        </p:nvGrpSpPr>
        <p:grpSpPr>
          <a:xfrm>
            <a:off x="2213134" y="2902266"/>
            <a:ext cx="861392" cy="1099219"/>
            <a:chOff x="5032878" y="4441382"/>
            <a:chExt cx="509132" cy="625139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2C9CFCA-464F-462F-8B38-0D9EA44A8D87}"/>
                </a:ext>
              </a:extLst>
            </p:cNvPr>
            <p:cNvSpPr txBox="1"/>
            <p:nvPr/>
          </p:nvSpPr>
          <p:spPr>
            <a:xfrm>
              <a:off x="5056321" y="4441382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D2A1635-FD7D-4E56-9FBD-0E85D1D16B55}"/>
                </a:ext>
              </a:extLst>
            </p:cNvPr>
            <p:cNvSpPr txBox="1"/>
            <p:nvPr/>
          </p:nvSpPr>
          <p:spPr>
            <a:xfrm>
              <a:off x="5032878" y="4835271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5-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5EB22213-9DE3-4413-92BE-A8DC9AC0B0AF}"/>
              </a:ext>
            </a:extLst>
          </p:cNvPr>
          <p:cNvSpPr txBox="1"/>
          <p:nvPr/>
        </p:nvSpPr>
        <p:spPr>
          <a:xfrm>
            <a:off x="2292544" y="6102633"/>
            <a:ext cx="762077" cy="340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E137CD39-35E1-4462-B269-9B1240C83B32}"/>
              </a:ext>
            </a:extLst>
          </p:cNvPr>
          <p:cNvGrpSpPr/>
          <p:nvPr/>
        </p:nvGrpSpPr>
        <p:grpSpPr>
          <a:xfrm>
            <a:off x="2232925" y="4379885"/>
            <a:ext cx="874835" cy="982851"/>
            <a:chOff x="5001490" y="4433845"/>
            <a:chExt cx="517077" cy="558959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4F26972-4DBD-41BC-9C50-6ECA9FA28121}"/>
                </a:ext>
              </a:extLst>
            </p:cNvPr>
            <p:cNvSpPr txBox="1"/>
            <p:nvPr/>
          </p:nvSpPr>
          <p:spPr>
            <a:xfrm>
              <a:off x="5001490" y="4433845"/>
              <a:ext cx="485689" cy="157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-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12C4A17-5C5B-4354-8DC8-6B47359654F9}"/>
                </a:ext>
              </a:extLst>
            </p:cNvPr>
            <p:cNvSpPr txBox="1"/>
            <p:nvPr/>
          </p:nvSpPr>
          <p:spPr>
            <a:xfrm>
              <a:off x="5032878" y="4835271"/>
              <a:ext cx="485689" cy="157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75-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CD0A7932-C663-47CD-A2E4-F6FE618DAC5E}"/>
              </a:ext>
            </a:extLst>
          </p:cNvPr>
          <p:cNvSpPr txBox="1"/>
          <p:nvPr/>
        </p:nvSpPr>
        <p:spPr>
          <a:xfrm>
            <a:off x="2239553" y="4757569"/>
            <a:ext cx="821730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</a:p>
        </p:txBody>
      </p:sp>
    </p:spTree>
    <p:extLst>
      <p:ext uri="{BB962C8B-B14F-4D97-AF65-F5344CB8AC3E}">
        <p14:creationId xmlns:p14="http://schemas.microsoft.com/office/powerpoint/2010/main" val="3064015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ark, photo, sitting, building&#10;&#10;Description automatically generated">
            <a:extLst>
              <a:ext uri="{FF2B5EF4-FFF2-40B4-BE49-F238E27FC236}">
                <a16:creationId xmlns:a16="http://schemas.microsoft.com/office/drawing/2014/main" id="{1111DA61-7217-474C-8D9B-535E4969FC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237" t="50774" r="18706" b="32996"/>
          <a:stretch/>
        </p:blipFill>
        <p:spPr>
          <a:xfrm>
            <a:off x="2599676" y="4106316"/>
            <a:ext cx="1894944" cy="1016343"/>
          </a:xfrm>
          <a:prstGeom prst="rect">
            <a:avLst/>
          </a:prstGeom>
        </p:spPr>
      </p:pic>
      <p:pic>
        <p:nvPicPr>
          <p:cNvPr id="6" name="Picture 5" descr="A picture containing dark, photo, television, sitting&#10;&#10;Description automatically generated">
            <a:extLst>
              <a:ext uri="{FF2B5EF4-FFF2-40B4-BE49-F238E27FC236}">
                <a16:creationId xmlns:a16="http://schemas.microsoft.com/office/drawing/2014/main" id="{F9C05D6E-C053-40A4-9CC4-6F6FEC8C6B3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16" t="35463" r="29024" b="51091"/>
          <a:stretch/>
        </p:blipFill>
        <p:spPr>
          <a:xfrm>
            <a:off x="2573172" y="5237179"/>
            <a:ext cx="2038268" cy="973339"/>
          </a:xfrm>
          <a:prstGeom prst="rect">
            <a:avLst/>
          </a:prstGeom>
        </p:spPr>
      </p:pic>
      <p:pic>
        <p:nvPicPr>
          <p:cNvPr id="7" name="Picture 6" descr="A picture containing building, photo, clock, dark&#10;&#10;Description automatically generated">
            <a:extLst>
              <a:ext uri="{FF2B5EF4-FFF2-40B4-BE49-F238E27FC236}">
                <a16:creationId xmlns:a16="http://schemas.microsoft.com/office/drawing/2014/main" id="{4950DE27-A47F-4D6E-A7B4-93DD4974D56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52" t="39793" r="29872" b="37272"/>
          <a:stretch/>
        </p:blipFill>
        <p:spPr>
          <a:xfrm>
            <a:off x="2533416" y="2907527"/>
            <a:ext cx="2025013" cy="107882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011129E-3D0B-4FC2-A0B4-EF2EA1869E88}"/>
              </a:ext>
            </a:extLst>
          </p:cNvPr>
          <p:cNvSpPr txBox="1"/>
          <p:nvPr/>
        </p:nvSpPr>
        <p:spPr>
          <a:xfrm>
            <a:off x="4503173" y="2987119"/>
            <a:ext cx="969741" cy="381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673877-22E5-4640-A373-68D0D5021CC0}"/>
              </a:ext>
            </a:extLst>
          </p:cNvPr>
          <p:cNvSpPr txBox="1"/>
          <p:nvPr/>
        </p:nvSpPr>
        <p:spPr>
          <a:xfrm>
            <a:off x="4536851" y="4484455"/>
            <a:ext cx="1360366" cy="381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PA3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65F863-74D2-4E3E-83B7-D7F5692B56A1}"/>
              </a:ext>
            </a:extLst>
          </p:cNvPr>
          <p:cNvSpPr txBox="1"/>
          <p:nvPr/>
        </p:nvSpPr>
        <p:spPr>
          <a:xfrm>
            <a:off x="4530925" y="5586637"/>
            <a:ext cx="1146962" cy="381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9653FF-9FDC-4D09-A660-E315F458400D}"/>
              </a:ext>
            </a:extLst>
          </p:cNvPr>
          <p:cNvSpPr txBox="1"/>
          <p:nvPr/>
        </p:nvSpPr>
        <p:spPr>
          <a:xfrm rot="16200000">
            <a:off x="2409461" y="2228359"/>
            <a:ext cx="1078825" cy="379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D1D3BB-8B59-4429-8B79-478DDDB9A479}"/>
              </a:ext>
            </a:extLst>
          </p:cNvPr>
          <p:cNvSpPr txBox="1"/>
          <p:nvPr/>
        </p:nvSpPr>
        <p:spPr>
          <a:xfrm rot="16200000">
            <a:off x="2835056" y="2235861"/>
            <a:ext cx="1078825" cy="379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T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53D089D-6D33-4345-83AE-C36E6FFC07C5}"/>
              </a:ext>
            </a:extLst>
          </p:cNvPr>
          <p:cNvSpPr txBox="1"/>
          <p:nvPr/>
        </p:nvSpPr>
        <p:spPr>
          <a:xfrm rot="16200000">
            <a:off x="3260653" y="2243364"/>
            <a:ext cx="1078825" cy="379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PX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68056FE-8DEA-440E-9873-EC7979BFA966}"/>
              </a:ext>
            </a:extLst>
          </p:cNvPr>
          <p:cNvSpPr txBox="1"/>
          <p:nvPr/>
        </p:nvSpPr>
        <p:spPr>
          <a:xfrm rot="16200000">
            <a:off x="3655449" y="2115429"/>
            <a:ext cx="1304697" cy="379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AD54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DB2920-AC9E-4735-86AF-6BB5E87AA886}"/>
              </a:ext>
            </a:extLst>
          </p:cNvPr>
          <p:cNvSpPr txBox="1"/>
          <p:nvPr/>
        </p:nvSpPr>
        <p:spPr>
          <a:xfrm>
            <a:off x="2900740" y="1457739"/>
            <a:ext cx="1680461" cy="381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O-1 Cell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023E0B-8BC7-4816-9712-F9C33FD41548}"/>
              </a:ext>
            </a:extLst>
          </p:cNvPr>
          <p:cNvSpPr txBox="1"/>
          <p:nvPr/>
        </p:nvSpPr>
        <p:spPr>
          <a:xfrm>
            <a:off x="510209" y="320171"/>
            <a:ext cx="3005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Supplementary Figure 4 a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C275E258-EEC2-42DC-B2A9-74E3C41814C2}"/>
              </a:ext>
            </a:extLst>
          </p:cNvPr>
          <p:cNvGrpSpPr/>
          <p:nvPr/>
        </p:nvGrpSpPr>
        <p:grpSpPr>
          <a:xfrm>
            <a:off x="2150715" y="2968517"/>
            <a:ext cx="738073" cy="536010"/>
            <a:chOff x="5047187" y="4549264"/>
            <a:chExt cx="526414" cy="447479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0C7B397-FBE7-48DB-9F94-857D9387D3D4}"/>
                </a:ext>
              </a:extLst>
            </p:cNvPr>
            <p:cNvSpPr txBox="1"/>
            <p:nvPr/>
          </p:nvSpPr>
          <p:spPr>
            <a:xfrm>
              <a:off x="5087912" y="4549264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64CC4CE-1988-491D-867E-27D3979ED4BC}"/>
                </a:ext>
              </a:extLst>
            </p:cNvPr>
            <p:cNvSpPr txBox="1"/>
            <p:nvPr/>
          </p:nvSpPr>
          <p:spPr>
            <a:xfrm>
              <a:off x="5047187" y="4765493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5-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6530851B-D07B-4840-8D51-577CE375D440}"/>
              </a:ext>
            </a:extLst>
          </p:cNvPr>
          <p:cNvGrpSpPr/>
          <p:nvPr/>
        </p:nvGrpSpPr>
        <p:grpSpPr>
          <a:xfrm>
            <a:off x="2252883" y="4412982"/>
            <a:ext cx="834886" cy="940234"/>
            <a:chOff x="5048544" y="4441382"/>
            <a:chExt cx="493466" cy="479357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4BB1A9E-B004-407C-B583-AB72B4FD5FE7}"/>
                </a:ext>
              </a:extLst>
            </p:cNvPr>
            <p:cNvSpPr txBox="1"/>
            <p:nvPr/>
          </p:nvSpPr>
          <p:spPr>
            <a:xfrm>
              <a:off x="5056321" y="4441382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31632C7-0163-4755-A786-BC5B7E2A6445}"/>
                </a:ext>
              </a:extLst>
            </p:cNvPr>
            <p:cNvSpPr txBox="1"/>
            <p:nvPr/>
          </p:nvSpPr>
          <p:spPr>
            <a:xfrm>
              <a:off x="5048544" y="4689489"/>
              <a:ext cx="485689" cy="2312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5-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AA1D49E8-4EB0-44B4-BCBC-6A147D012D96}"/>
              </a:ext>
            </a:extLst>
          </p:cNvPr>
          <p:cNvSpPr txBox="1"/>
          <p:nvPr/>
        </p:nvSpPr>
        <p:spPr>
          <a:xfrm>
            <a:off x="2252774" y="5691797"/>
            <a:ext cx="762076" cy="34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</a:p>
        </p:txBody>
      </p:sp>
    </p:spTree>
    <p:extLst>
      <p:ext uri="{BB962C8B-B14F-4D97-AF65-F5344CB8AC3E}">
        <p14:creationId xmlns:p14="http://schemas.microsoft.com/office/powerpoint/2010/main" val="1685013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041</TotalTime>
  <Words>161</Words>
  <Application>Microsoft Macintosh PowerPoint</Application>
  <PresentationFormat>On-screen Show (4:3)</PresentationFormat>
  <Paragraphs>7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sood</dc:creator>
  <cp:lastModifiedBy>Shammas, Masood</cp:lastModifiedBy>
  <cp:revision>1285</cp:revision>
  <dcterms:created xsi:type="dcterms:W3CDTF">2017-05-08T19:06:17Z</dcterms:created>
  <dcterms:modified xsi:type="dcterms:W3CDTF">2021-03-10T02:56:25Z</dcterms:modified>
</cp:coreProperties>
</file>